
<file path=[Content_Types].xml><?xml version="1.0" encoding="utf-8"?>
<Types xmlns="http://schemas.openxmlformats.org/package/2006/content-types">
  <Default Extension="emf" ContentType="image/x-emf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6"/>
  </p:notesMasterIdLst>
  <p:sldIdLst>
    <p:sldId id="279" r:id="rId2"/>
    <p:sldId id="271" r:id="rId3"/>
    <p:sldId id="274" r:id="rId4"/>
    <p:sldId id="268" r:id="rId5"/>
  </p:sldIdLst>
  <p:sldSz cx="36152138" cy="51120675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yunaisec" initials="s" lastIdx="1" clrIdx="0">
    <p:extLst>
      <p:ext uri="{19B8F6BF-5375-455C-9EA6-DF929625EA0E}">
        <p15:presenceInfo xmlns:p15="http://schemas.microsoft.com/office/powerpoint/2012/main" userId="syunaisec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D113A9D2-9D6B-4929-AA2D-F23B5EE8CBE7}" styleName="テーマ スタイル 2 - アクセント 1">
    <a:tblBg>
      <a:fillRef idx="3">
        <a:schemeClr val="accent1"/>
      </a:fillRef>
      <a:effectRef idx="3">
        <a:schemeClr val="accent1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1">
                <a:tint val="50000"/>
              </a:schemeClr>
            </a:lnRef>
          </a:left>
          <a:right>
            <a:lnRef idx="1">
              <a:schemeClr val="accent1">
                <a:tint val="50000"/>
              </a:schemeClr>
            </a:lnRef>
          </a:right>
          <a:top>
            <a:lnRef idx="1">
              <a:schemeClr val="accent1">
                <a:tint val="50000"/>
              </a:schemeClr>
            </a:lnRef>
          </a:top>
          <a:bottom>
            <a:lnRef idx="1">
              <a:schemeClr val="accent1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71" autoAdjust="0"/>
    <p:restoredTop sz="95394" autoAdjust="0"/>
  </p:normalViewPr>
  <p:slideViewPr>
    <p:cSldViewPr snapToGrid="0">
      <p:cViewPr varScale="1">
        <p:scale>
          <a:sx n="10" d="100"/>
          <a:sy n="10" d="100"/>
        </p:scale>
        <p:origin x="2538" y="2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酒井 瞳" userId="151b022e61acaa87" providerId="LiveId" clId="{BD249EA3-8210-4121-936C-05825C06624F}"/>
    <pc:docChg chg="modSld">
      <pc:chgData name="酒井 瞳" userId="151b022e61acaa87" providerId="LiveId" clId="{BD249EA3-8210-4121-936C-05825C06624F}" dt="2021-03-26T21:56:45.504" v="10" actId="1076"/>
      <pc:docMkLst>
        <pc:docMk/>
      </pc:docMkLst>
      <pc:sldChg chg="modSp mod">
        <pc:chgData name="酒井 瞳" userId="151b022e61acaa87" providerId="LiveId" clId="{BD249EA3-8210-4121-936C-05825C06624F}" dt="2021-03-26T21:56:45.504" v="10" actId="1076"/>
        <pc:sldMkLst>
          <pc:docMk/>
          <pc:sldMk cId="3429435632" sldId="270"/>
        </pc:sldMkLst>
        <pc:grpChg chg="mod">
          <ac:chgData name="酒井 瞳" userId="151b022e61acaa87" providerId="LiveId" clId="{BD249EA3-8210-4121-936C-05825C06624F}" dt="2021-03-26T21:56:24.063" v="7" actId="14100"/>
          <ac:grpSpMkLst>
            <pc:docMk/>
            <pc:sldMk cId="3429435632" sldId="270"/>
            <ac:grpSpMk id="4" creationId="{C037CA13-85A0-44C4-86A7-68055DE98D94}"/>
          </ac:grpSpMkLst>
        </pc:grpChg>
        <pc:grpChg chg="mod">
          <ac:chgData name="酒井 瞳" userId="151b022e61acaa87" providerId="LiveId" clId="{BD249EA3-8210-4121-936C-05825C06624F}" dt="2021-03-26T21:56:45.504" v="10" actId="1076"/>
          <ac:grpSpMkLst>
            <pc:docMk/>
            <pc:sldMk cId="3429435632" sldId="270"/>
            <ac:grpSpMk id="5" creationId="{EA611487-3ECC-47C5-88E9-EF7F8B8BBBC9}"/>
          </ac:grpSpMkLst>
        </pc:grpChg>
        <pc:picChg chg="mod modCrop">
          <ac:chgData name="酒井 瞳" userId="151b022e61acaa87" providerId="LiveId" clId="{BD249EA3-8210-4121-936C-05825C06624F}" dt="2021-03-26T21:55:12.573" v="2" actId="732"/>
          <ac:picMkLst>
            <pc:docMk/>
            <pc:sldMk cId="3429435632" sldId="270"/>
            <ac:picMk id="7" creationId="{11E564FD-1B3F-48C3-B99F-93B9F810B390}"/>
          </ac:picMkLst>
        </pc:picChg>
        <pc:picChg chg="mod modCrop">
          <ac:chgData name="酒井 瞳" userId="151b022e61acaa87" providerId="LiveId" clId="{BD249EA3-8210-4121-936C-05825C06624F}" dt="2021-03-26T21:56:40.631" v="9" actId="732"/>
          <ac:picMkLst>
            <pc:docMk/>
            <pc:sldMk cId="3429435632" sldId="270"/>
            <ac:picMk id="18" creationId="{722AC4E2-958B-4C77-927A-7ECAD788C7FA}"/>
          </ac:picMkLst>
        </pc:picChg>
      </pc:sldChg>
    </pc:docChg>
  </pc:docChgLst>
  <pc:docChgLst>
    <pc:chgData name="酒井 瞳" userId="151b022e61acaa87" providerId="LiveId" clId="{5C013071-EA3E-4EE2-9FAE-F13CAF18258C}"/>
    <pc:docChg chg="undo custSel modSld">
      <pc:chgData name="酒井 瞳" userId="151b022e61acaa87" providerId="LiveId" clId="{5C013071-EA3E-4EE2-9FAE-F13CAF18258C}" dt="2021-03-26T11:51:33.857" v="21" actId="164"/>
      <pc:docMkLst>
        <pc:docMk/>
      </pc:docMkLst>
      <pc:sldChg chg="addSp delSp modSp mod">
        <pc:chgData name="酒井 瞳" userId="151b022e61acaa87" providerId="LiveId" clId="{5C013071-EA3E-4EE2-9FAE-F13CAF18258C}" dt="2021-03-26T11:51:33.857" v="21" actId="164"/>
        <pc:sldMkLst>
          <pc:docMk/>
          <pc:sldMk cId="3429435632" sldId="270"/>
        </pc:sldMkLst>
        <pc:spChg chg="mod topLvl">
          <ac:chgData name="酒井 瞳" userId="151b022e61acaa87" providerId="LiveId" clId="{5C013071-EA3E-4EE2-9FAE-F13CAF18258C}" dt="2021-03-26T11:51:28.773" v="20" actId="164"/>
          <ac:spMkLst>
            <pc:docMk/>
            <pc:sldMk cId="3429435632" sldId="270"/>
            <ac:spMk id="33" creationId="{78639AF7-220E-4819-8F07-0083041F191D}"/>
          </ac:spMkLst>
        </pc:spChg>
        <pc:spChg chg="add del mod topLvl">
          <ac:chgData name="酒井 瞳" userId="151b022e61acaa87" providerId="LiveId" clId="{5C013071-EA3E-4EE2-9FAE-F13CAF18258C}" dt="2021-03-26T11:51:33.857" v="21" actId="164"/>
          <ac:spMkLst>
            <pc:docMk/>
            <pc:sldMk cId="3429435632" sldId="270"/>
            <ac:spMk id="37" creationId="{131E7033-7E9F-49F4-8B90-759BB56D88B7}"/>
          </ac:spMkLst>
        </pc:spChg>
        <pc:grpChg chg="del">
          <ac:chgData name="酒井 瞳" userId="151b022e61acaa87" providerId="LiveId" clId="{5C013071-EA3E-4EE2-9FAE-F13CAF18258C}" dt="2021-03-26T11:51:07.856" v="16" actId="165"/>
          <ac:grpSpMkLst>
            <pc:docMk/>
            <pc:sldMk cId="3429435632" sldId="270"/>
            <ac:grpSpMk id="19" creationId="{45838B86-DA37-445D-93A4-11308D249ABC}"/>
          </ac:grpSpMkLst>
        </pc:grpChg>
        <pc:grpChg chg="del mod">
          <ac:chgData name="酒井 瞳" userId="151b022e61acaa87" providerId="LiveId" clId="{5C013071-EA3E-4EE2-9FAE-F13CAF18258C}" dt="2021-03-26T11:50:36.997" v="9" actId="165"/>
          <ac:grpSpMkLst>
            <pc:docMk/>
            <pc:sldMk cId="3429435632" sldId="270"/>
            <ac:grpSpMk id="24" creationId="{02317BE6-1FEF-47DD-9131-0EAAD81CB631}"/>
          </ac:grpSpMkLst>
        </pc:grpChg>
        <pc:grpChg chg="add mod">
          <ac:chgData name="酒井 瞳" userId="151b022e61acaa87" providerId="LiveId" clId="{5C013071-EA3E-4EE2-9FAE-F13CAF18258C}" dt="2021-03-26T11:51:28.773" v="20" actId="164"/>
          <ac:grpSpMkLst>
            <pc:docMk/>
            <pc:sldMk cId="3429435632" sldId="270"/>
            <ac:grpSpMk id="41" creationId="{9F4E1FBD-0BF3-41B3-B5D7-E73EBDDDEABB}"/>
          </ac:grpSpMkLst>
        </pc:grpChg>
        <pc:grpChg chg="add mod">
          <ac:chgData name="酒井 瞳" userId="151b022e61acaa87" providerId="LiveId" clId="{5C013071-EA3E-4EE2-9FAE-F13CAF18258C}" dt="2021-03-26T11:51:33.857" v="21" actId="164"/>
          <ac:grpSpMkLst>
            <pc:docMk/>
            <pc:sldMk cId="3429435632" sldId="270"/>
            <ac:grpSpMk id="42" creationId="{264E5ED4-274A-4174-A285-6BF5D841057E}"/>
          </ac:grpSpMkLst>
        </pc:grpChg>
        <pc:picChg chg="del mod topLvl">
          <ac:chgData name="酒井 瞳" userId="151b022e61acaa87" providerId="LiveId" clId="{5C013071-EA3E-4EE2-9FAE-F13CAF18258C}" dt="2021-03-26T11:51:11.036" v="17" actId="21"/>
          <ac:picMkLst>
            <pc:docMk/>
            <pc:sldMk cId="3429435632" sldId="270"/>
            <ac:picMk id="8" creationId="{1E5EE8AD-A805-4BAF-9BD4-F7E03224668D}"/>
          </ac:picMkLst>
        </pc:picChg>
        <pc:picChg chg="add del mod">
          <ac:chgData name="酒井 瞳" userId="151b022e61acaa87" providerId="LiveId" clId="{5C013071-EA3E-4EE2-9FAE-F13CAF18258C}" dt="2021-03-26T11:48:52.735" v="2" actId="21"/>
          <ac:picMkLst>
            <pc:docMk/>
            <pc:sldMk cId="3429435632" sldId="270"/>
            <ac:picMk id="9" creationId="{8F16B33A-99BE-439A-AA31-3A14C641C765}"/>
          </ac:picMkLst>
        </pc:picChg>
        <pc:picChg chg="add del mod topLvl">
          <ac:chgData name="酒井 瞳" userId="151b022e61acaa87" providerId="LiveId" clId="{5C013071-EA3E-4EE2-9FAE-F13CAF18258C}" dt="2021-03-26T11:50:44.462" v="12" actId="21"/>
          <ac:picMkLst>
            <pc:docMk/>
            <pc:sldMk cId="3429435632" sldId="270"/>
            <ac:picMk id="15" creationId="{A16CEFA5-E6E0-43CA-ABD4-2E74368314D3}"/>
          </ac:picMkLst>
        </pc:picChg>
        <pc:picChg chg="add del mod">
          <ac:chgData name="酒井 瞳" userId="151b022e61acaa87" providerId="LiveId" clId="{5C013071-EA3E-4EE2-9FAE-F13CAF18258C}" dt="2021-03-26T11:50:30.043" v="7" actId="21"/>
          <ac:picMkLst>
            <pc:docMk/>
            <pc:sldMk cId="3429435632" sldId="270"/>
            <ac:picMk id="29" creationId="{6F507EAE-97F5-4E27-9E90-5B0A32BD6605}"/>
          </ac:picMkLst>
        </pc:picChg>
        <pc:picChg chg="add mod">
          <ac:chgData name="酒井 瞳" userId="151b022e61acaa87" providerId="LiveId" clId="{5C013071-EA3E-4EE2-9FAE-F13CAF18258C}" dt="2021-03-26T11:51:33.857" v="21" actId="164"/>
          <ac:picMkLst>
            <pc:docMk/>
            <pc:sldMk cId="3429435632" sldId="270"/>
            <ac:picMk id="32" creationId="{03B15A9E-3513-42C5-908E-4432AAC13B31}"/>
          </ac:picMkLst>
        </pc:picChg>
        <pc:picChg chg="add mod">
          <ac:chgData name="酒井 瞳" userId="151b022e61acaa87" providerId="LiveId" clId="{5C013071-EA3E-4EE2-9FAE-F13CAF18258C}" dt="2021-03-26T11:51:28.773" v="20" actId="164"/>
          <ac:picMkLst>
            <pc:docMk/>
            <pc:sldMk cId="3429435632" sldId="270"/>
            <ac:picMk id="36" creationId="{C81E70CB-27FA-40C3-A45C-82067FDA3088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0CCA0A-2098-40F2-96C5-D11E4DB2957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1243013"/>
            <a:ext cx="23717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419F07-D54D-4B42-AE3E-71ABD822AF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69357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907585" rtl="0" eaLnBrk="1" latinLnBrk="0" hangingPunct="1">
      <a:defRPr kumimoji="1" sz="6440" kern="1200">
        <a:solidFill>
          <a:schemeClr val="tx1"/>
        </a:solidFill>
        <a:latin typeface="+mn-lt"/>
        <a:ea typeface="+mn-ea"/>
        <a:cs typeface="+mn-cs"/>
      </a:defRPr>
    </a:lvl1pPr>
    <a:lvl2pPr marL="2453792" algn="l" defTabSz="4907585" rtl="0" eaLnBrk="1" latinLnBrk="0" hangingPunct="1">
      <a:defRPr kumimoji="1" sz="6440" kern="1200">
        <a:solidFill>
          <a:schemeClr val="tx1"/>
        </a:solidFill>
        <a:latin typeface="+mn-lt"/>
        <a:ea typeface="+mn-ea"/>
        <a:cs typeface="+mn-cs"/>
      </a:defRPr>
    </a:lvl2pPr>
    <a:lvl3pPr marL="4907585" algn="l" defTabSz="4907585" rtl="0" eaLnBrk="1" latinLnBrk="0" hangingPunct="1">
      <a:defRPr kumimoji="1" sz="6440" kern="1200">
        <a:solidFill>
          <a:schemeClr val="tx1"/>
        </a:solidFill>
        <a:latin typeface="+mn-lt"/>
        <a:ea typeface="+mn-ea"/>
        <a:cs typeface="+mn-cs"/>
      </a:defRPr>
    </a:lvl3pPr>
    <a:lvl4pPr marL="7361377" algn="l" defTabSz="4907585" rtl="0" eaLnBrk="1" latinLnBrk="0" hangingPunct="1">
      <a:defRPr kumimoji="1" sz="6440" kern="1200">
        <a:solidFill>
          <a:schemeClr val="tx1"/>
        </a:solidFill>
        <a:latin typeface="+mn-lt"/>
        <a:ea typeface="+mn-ea"/>
        <a:cs typeface="+mn-cs"/>
      </a:defRPr>
    </a:lvl4pPr>
    <a:lvl5pPr marL="9815170" algn="l" defTabSz="4907585" rtl="0" eaLnBrk="1" latinLnBrk="0" hangingPunct="1">
      <a:defRPr kumimoji="1" sz="6440" kern="1200">
        <a:solidFill>
          <a:schemeClr val="tx1"/>
        </a:solidFill>
        <a:latin typeface="+mn-lt"/>
        <a:ea typeface="+mn-ea"/>
        <a:cs typeface="+mn-cs"/>
      </a:defRPr>
    </a:lvl5pPr>
    <a:lvl6pPr marL="12268962" algn="l" defTabSz="4907585" rtl="0" eaLnBrk="1" latinLnBrk="0" hangingPunct="1">
      <a:defRPr kumimoji="1" sz="6440" kern="1200">
        <a:solidFill>
          <a:schemeClr val="tx1"/>
        </a:solidFill>
        <a:latin typeface="+mn-lt"/>
        <a:ea typeface="+mn-ea"/>
        <a:cs typeface="+mn-cs"/>
      </a:defRPr>
    </a:lvl6pPr>
    <a:lvl7pPr marL="14722754" algn="l" defTabSz="4907585" rtl="0" eaLnBrk="1" latinLnBrk="0" hangingPunct="1">
      <a:defRPr kumimoji="1" sz="6440" kern="1200">
        <a:solidFill>
          <a:schemeClr val="tx1"/>
        </a:solidFill>
        <a:latin typeface="+mn-lt"/>
        <a:ea typeface="+mn-ea"/>
        <a:cs typeface="+mn-cs"/>
      </a:defRPr>
    </a:lvl7pPr>
    <a:lvl8pPr marL="17176547" algn="l" defTabSz="4907585" rtl="0" eaLnBrk="1" latinLnBrk="0" hangingPunct="1">
      <a:defRPr kumimoji="1" sz="6440" kern="1200">
        <a:solidFill>
          <a:schemeClr val="tx1"/>
        </a:solidFill>
        <a:latin typeface="+mn-lt"/>
        <a:ea typeface="+mn-ea"/>
        <a:cs typeface="+mn-cs"/>
      </a:defRPr>
    </a:lvl8pPr>
    <a:lvl9pPr marL="19630339" algn="l" defTabSz="4907585" rtl="0" eaLnBrk="1" latinLnBrk="0" hangingPunct="1">
      <a:defRPr kumimoji="1" sz="644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217738" y="1243013"/>
            <a:ext cx="2371725" cy="3354387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Positive</a:t>
            </a:r>
            <a:r>
              <a:rPr kumimoji="1" lang="ja-JP" altLang="en-US" dirty="0"/>
              <a:t>と</a:t>
            </a:r>
            <a:r>
              <a:rPr kumimoji="1" lang="en-US" altLang="ja-JP"/>
              <a:t>weak 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2419F07-D54D-4B42-AE3E-71ABD822AFA6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08314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711411" y="8366281"/>
            <a:ext cx="30729317" cy="17797568"/>
          </a:xfrm>
        </p:spPr>
        <p:txBody>
          <a:bodyPr anchor="b"/>
          <a:lstStyle>
            <a:lvl1pPr algn="ctr">
              <a:defRPr sz="2372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519017" y="26850192"/>
            <a:ext cx="27114104" cy="12342326"/>
          </a:xfrm>
        </p:spPr>
        <p:txBody>
          <a:bodyPr/>
          <a:lstStyle>
            <a:lvl1pPr marL="0" indent="0" algn="ctr">
              <a:buNone/>
              <a:defRPr sz="9489"/>
            </a:lvl1pPr>
            <a:lvl2pPr marL="1807586" indent="0" algn="ctr">
              <a:buNone/>
              <a:defRPr sz="7907"/>
            </a:lvl2pPr>
            <a:lvl3pPr marL="3615172" indent="0" algn="ctr">
              <a:buNone/>
              <a:defRPr sz="7116"/>
            </a:lvl3pPr>
            <a:lvl4pPr marL="5422758" indent="0" algn="ctr">
              <a:buNone/>
              <a:defRPr sz="6326"/>
            </a:lvl4pPr>
            <a:lvl5pPr marL="7230344" indent="0" algn="ctr">
              <a:buNone/>
              <a:defRPr sz="6326"/>
            </a:lvl5pPr>
            <a:lvl6pPr marL="9037930" indent="0" algn="ctr">
              <a:buNone/>
              <a:defRPr sz="6326"/>
            </a:lvl6pPr>
            <a:lvl7pPr marL="10845516" indent="0" algn="ctr">
              <a:buNone/>
              <a:defRPr sz="6326"/>
            </a:lvl7pPr>
            <a:lvl8pPr marL="12653101" indent="0" algn="ctr">
              <a:buNone/>
              <a:defRPr sz="6326"/>
            </a:lvl8pPr>
            <a:lvl9pPr marL="14460687" indent="0" algn="ctr">
              <a:buNone/>
              <a:defRPr sz="6326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DB5E8-7F1D-4D4A-BF31-59CD61463A2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9423D-0300-4726-B9C6-00DF37BC2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98971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DB5E8-7F1D-4D4A-BF31-59CD61463A2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9423D-0300-4726-B9C6-00DF37BC2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5706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5871376" y="2721703"/>
            <a:ext cx="7795305" cy="4332240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485461" y="2721703"/>
            <a:ext cx="22934013" cy="4332240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DB5E8-7F1D-4D4A-BF31-59CD61463A2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9423D-0300-4726-B9C6-00DF37BC2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25411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DB5E8-7F1D-4D4A-BF31-59CD61463A2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9423D-0300-4726-B9C6-00DF37BC2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58701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66632" y="12744683"/>
            <a:ext cx="31181219" cy="21264777"/>
          </a:xfrm>
        </p:spPr>
        <p:txBody>
          <a:bodyPr anchor="b"/>
          <a:lstStyle>
            <a:lvl1pPr>
              <a:defRPr sz="2372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66632" y="34210633"/>
            <a:ext cx="31181219" cy="11182644"/>
          </a:xfrm>
        </p:spPr>
        <p:txBody>
          <a:bodyPr/>
          <a:lstStyle>
            <a:lvl1pPr marL="0" indent="0">
              <a:buNone/>
              <a:defRPr sz="9489">
                <a:solidFill>
                  <a:schemeClr val="tx1"/>
                </a:solidFill>
              </a:defRPr>
            </a:lvl1pPr>
            <a:lvl2pPr marL="1807586" indent="0">
              <a:buNone/>
              <a:defRPr sz="7907">
                <a:solidFill>
                  <a:schemeClr val="tx1">
                    <a:tint val="75000"/>
                  </a:schemeClr>
                </a:solidFill>
              </a:defRPr>
            </a:lvl2pPr>
            <a:lvl3pPr marL="3615172" indent="0">
              <a:buNone/>
              <a:defRPr sz="7116">
                <a:solidFill>
                  <a:schemeClr val="tx1">
                    <a:tint val="75000"/>
                  </a:schemeClr>
                </a:solidFill>
              </a:defRPr>
            </a:lvl3pPr>
            <a:lvl4pPr marL="5422758" indent="0">
              <a:buNone/>
              <a:defRPr sz="6326">
                <a:solidFill>
                  <a:schemeClr val="tx1">
                    <a:tint val="75000"/>
                  </a:schemeClr>
                </a:solidFill>
              </a:defRPr>
            </a:lvl4pPr>
            <a:lvl5pPr marL="7230344" indent="0">
              <a:buNone/>
              <a:defRPr sz="6326">
                <a:solidFill>
                  <a:schemeClr val="tx1">
                    <a:tint val="75000"/>
                  </a:schemeClr>
                </a:solidFill>
              </a:defRPr>
            </a:lvl5pPr>
            <a:lvl6pPr marL="9037930" indent="0">
              <a:buNone/>
              <a:defRPr sz="6326">
                <a:solidFill>
                  <a:schemeClr val="tx1">
                    <a:tint val="75000"/>
                  </a:schemeClr>
                </a:solidFill>
              </a:defRPr>
            </a:lvl6pPr>
            <a:lvl7pPr marL="10845516" indent="0">
              <a:buNone/>
              <a:defRPr sz="6326">
                <a:solidFill>
                  <a:schemeClr val="tx1">
                    <a:tint val="75000"/>
                  </a:schemeClr>
                </a:solidFill>
              </a:defRPr>
            </a:lvl7pPr>
            <a:lvl8pPr marL="12653101" indent="0">
              <a:buNone/>
              <a:defRPr sz="6326">
                <a:solidFill>
                  <a:schemeClr val="tx1">
                    <a:tint val="75000"/>
                  </a:schemeClr>
                </a:solidFill>
              </a:defRPr>
            </a:lvl8pPr>
            <a:lvl9pPr marL="14460687" indent="0">
              <a:buNone/>
              <a:defRPr sz="632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DB5E8-7F1D-4D4A-BF31-59CD61463A2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9423D-0300-4726-B9C6-00DF37BC2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08364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485459" y="13608513"/>
            <a:ext cx="15364659" cy="3243559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302020" y="13608513"/>
            <a:ext cx="15364659" cy="3243559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DB5E8-7F1D-4D4A-BF31-59CD61463A2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9423D-0300-4726-B9C6-00DF37BC2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71993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90168" y="2721714"/>
            <a:ext cx="31181219" cy="9880968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90172" y="12531669"/>
            <a:ext cx="15294047" cy="6141577"/>
          </a:xfrm>
        </p:spPr>
        <p:txBody>
          <a:bodyPr anchor="b"/>
          <a:lstStyle>
            <a:lvl1pPr marL="0" indent="0">
              <a:buNone/>
              <a:defRPr sz="9489" b="1"/>
            </a:lvl1pPr>
            <a:lvl2pPr marL="1807586" indent="0">
              <a:buNone/>
              <a:defRPr sz="7907" b="1"/>
            </a:lvl2pPr>
            <a:lvl3pPr marL="3615172" indent="0">
              <a:buNone/>
              <a:defRPr sz="7116" b="1"/>
            </a:lvl3pPr>
            <a:lvl4pPr marL="5422758" indent="0">
              <a:buNone/>
              <a:defRPr sz="6326" b="1"/>
            </a:lvl4pPr>
            <a:lvl5pPr marL="7230344" indent="0">
              <a:buNone/>
              <a:defRPr sz="6326" b="1"/>
            </a:lvl5pPr>
            <a:lvl6pPr marL="9037930" indent="0">
              <a:buNone/>
              <a:defRPr sz="6326" b="1"/>
            </a:lvl6pPr>
            <a:lvl7pPr marL="10845516" indent="0">
              <a:buNone/>
              <a:defRPr sz="6326" b="1"/>
            </a:lvl7pPr>
            <a:lvl8pPr marL="12653101" indent="0">
              <a:buNone/>
              <a:defRPr sz="6326" b="1"/>
            </a:lvl8pPr>
            <a:lvl9pPr marL="14460687" indent="0">
              <a:buNone/>
              <a:defRPr sz="6326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90172" y="18673247"/>
            <a:ext cx="15294047" cy="2746553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302022" y="12531669"/>
            <a:ext cx="15369367" cy="6141577"/>
          </a:xfrm>
        </p:spPr>
        <p:txBody>
          <a:bodyPr anchor="b"/>
          <a:lstStyle>
            <a:lvl1pPr marL="0" indent="0">
              <a:buNone/>
              <a:defRPr sz="9489" b="1"/>
            </a:lvl1pPr>
            <a:lvl2pPr marL="1807586" indent="0">
              <a:buNone/>
              <a:defRPr sz="7907" b="1"/>
            </a:lvl2pPr>
            <a:lvl3pPr marL="3615172" indent="0">
              <a:buNone/>
              <a:defRPr sz="7116" b="1"/>
            </a:lvl3pPr>
            <a:lvl4pPr marL="5422758" indent="0">
              <a:buNone/>
              <a:defRPr sz="6326" b="1"/>
            </a:lvl4pPr>
            <a:lvl5pPr marL="7230344" indent="0">
              <a:buNone/>
              <a:defRPr sz="6326" b="1"/>
            </a:lvl5pPr>
            <a:lvl6pPr marL="9037930" indent="0">
              <a:buNone/>
              <a:defRPr sz="6326" b="1"/>
            </a:lvl6pPr>
            <a:lvl7pPr marL="10845516" indent="0">
              <a:buNone/>
              <a:defRPr sz="6326" b="1"/>
            </a:lvl7pPr>
            <a:lvl8pPr marL="12653101" indent="0">
              <a:buNone/>
              <a:defRPr sz="6326" b="1"/>
            </a:lvl8pPr>
            <a:lvl9pPr marL="14460687" indent="0">
              <a:buNone/>
              <a:defRPr sz="6326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302022" y="18673247"/>
            <a:ext cx="15369367" cy="2746553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DB5E8-7F1D-4D4A-BF31-59CD61463A2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9423D-0300-4726-B9C6-00DF37BC2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96594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DB5E8-7F1D-4D4A-BF31-59CD61463A2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9423D-0300-4726-B9C6-00DF37BC2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6157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DB5E8-7F1D-4D4A-BF31-59CD61463A2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9423D-0300-4726-B9C6-00DF37BC2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18768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90169" y="3408045"/>
            <a:ext cx="11660005" cy="11928158"/>
          </a:xfrm>
        </p:spPr>
        <p:txBody>
          <a:bodyPr anchor="b"/>
          <a:lstStyle>
            <a:lvl1pPr>
              <a:defRPr sz="1265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369367" y="7360442"/>
            <a:ext cx="18302020" cy="36328813"/>
          </a:xfrm>
        </p:spPr>
        <p:txBody>
          <a:bodyPr/>
          <a:lstStyle>
            <a:lvl1pPr>
              <a:defRPr sz="12652"/>
            </a:lvl1pPr>
            <a:lvl2pPr>
              <a:defRPr sz="11070"/>
            </a:lvl2pPr>
            <a:lvl3pPr>
              <a:defRPr sz="9489"/>
            </a:lvl3pPr>
            <a:lvl4pPr>
              <a:defRPr sz="7907"/>
            </a:lvl4pPr>
            <a:lvl5pPr>
              <a:defRPr sz="7907"/>
            </a:lvl5pPr>
            <a:lvl6pPr>
              <a:defRPr sz="7907"/>
            </a:lvl6pPr>
            <a:lvl7pPr>
              <a:defRPr sz="7907"/>
            </a:lvl7pPr>
            <a:lvl8pPr>
              <a:defRPr sz="7907"/>
            </a:lvl8pPr>
            <a:lvl9pPr>
              <a:defRPr sz="790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90169" y="15336203"/>
            <a:ext cx="11660005" cy="28412212"/>
          </a:xfrm>
        </p:spPr>
        <p:txBody>
          <a:bodyPr/>
          <a:lstStyle>
            <a:lvl1pPr marL="0" indent="0">
              <a:buNone/>
              <a:defRPr sz="6326"/>
            </a:lvl1pPr>
            <a:lvl2pPr marL="1807586" indent="0">
              <a:buNone/>
              <a:defRPr sz="5535"/>
            </a:lvl2pPr>
            <a:lvl3pPr marL="3615172" indent="0">
              <a:buNone/>
              <a:defRPr sz="4744"/>
            </a:lvl3pPr>
            <a:lvl4pPr marL="5422758" indent="0">
              <a:buNone/>
              <a:defRPr sz="3954"/>
            </a:lvl4pPr>
            <a:lvl5pPr marL="7230344" indent="0">
              <a:buNone/>
              <a:defRPr sz="3954"/>
            </a:lvl5pPr>
            <a:lvl6pPr marL="9037930" indent="0">
              <a:buNone/>
              <a:defRPr sz="3954"/>
            </a:lvl6pPr>
            <a:lvl7pPr marL="10845516" indent="0">
              <a:buNone/>
              <a:defRPr sz="3954"/>
            </a:lvl7pPr>
            <a:lvl8pPr marL="12653101" indent="0">
              <a:buNone/>
              <a:defRPr sz="3954"/>
            </a:lvl8pPr>
            <a:lvl9pPr marL="14460687" indent="0">
              <a:buNone/>
              <a:defRPr sz="395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DB5E8-7F1D-4D4A-BF31-59CD61463A2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9423D-0300-4726-B9C6-00DF37BC2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5377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90169" y="3408045"/>
            <a:ext cx="11660005" cy="11928158"/>
          </a:xfrm>
        </p:spPr>
        <p:txBody>
          <a:bodyPr anchor="b"/>
          <a:lstStyle>
            <a:lvl1pPr>
              <a:defRPr sz="1265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369367" y="7360442"/>
            <a:ext cx="18302020" cy="36328813"/>
          </a:xfrm>
        </p:spPr>
        <p:txBody>
          <a:bodyPr anchor="t"/>
          <a:lstStyle>
            <a:lvl1pPr marL="0" indent="0">
              <a:buNone/>
              <a:defRPr sz="12652"/>
            </a:lvl1pPr>
            <a:lvl2pPr marL="1807586" indent="0">
              <a:buNone/>
              <a:defRPr sz="11070"/>
            </a:lvl2pPr>
            <a:lvl3pPr marL="3615172" indent="0">
              <a:buNone/>
              <a:defRPr sz="9489"/>
            </a:lvl3pPr>
            <a:lvl4pPr marL="5422758" indent="0">
              <a:buNone/>
              <a:defRPr sz="7907"/>
            </a:lvl4pPr>
            <a:lvl5pPr marL="7230344" indent="0">
              <a:buNone/>
              <a:defRPr sz="7907"/>
            </a:lvl5pPr>
            <a:lvl6pPr marL="9037930" indent="0">
              <a:buNone/>
              <a:defRPr sz="7907"/>
            </a:lvl6pPr>
            <a:lvl7pPr marL="10845516" indent="0">
              <a:buNone/>
              <a:defRPr sz="7907"/>
            </a:lvl7pPr>
            <a:lvl8pPr marL="12653101" indent="0">
              <a:buNone/>
              <a:defRPr sz="7907"/>
            </a:lvl8pPr>
            <a:lvl9pPr marL="14460687" indent="0">
              <a:buNone/>
              <a:defRPr sz="7907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90169" y="15336203"/>
            <a:ext cx="11660005" cy="28412212"/>
          </a:xfrm>
        </p:spPr>
        <p:txBody>
          <a:bodyPr/>
          <a:lstStyle>
            <a:lvl1pPr marL="0" indent="0">
              <a:buNone/>
              <a:defRPr sz="6326"/>
            </a:lvl1pPr>
            <a:lvl2pPr marL="1807586" indent="0">
              <a:buNone/>
              <a:defRPr sz="5535"/>
            </a:lvl2pPr>
            <a:lvl3pPr marL="3615172" indent="0">
              <a:buNone/>
              <a:defRPr sz="4744"/>
            </a:lvl3pPr>
            <a:lvl4pPr marL="5422758" indent="0">
              <a:buNone/>
              <a:defRPr sz="3954"/>
            </a:lvl4pPr>
            <a:lvl5pPr marL="7230344" indent="0">
              <a:buNone/>
              <a:defRPr sz="3954"/>
            </a:lvl5pPr>
            <a:lvl6pPr marL="9037930" indent="0">
              <a:buNone/>
              <a:defRPr sz="3954"/>
            </a:lvl6pPr>
            <a:lvl7pPr marL="10845516" indent="0">
              <a:buNone/>
              <a:defRPr sz="3954"/>
            </a:lvl7pPr>
            <a:lvl8pPr marL="12653101" indent="0">
              <a:buNone/>
              <a:defRPr sz="3954"/>
            </a:lvl8pPr>
            <a:lvl9pPr marL="14460687" indent="0">
              <a:buNone/>
              <a:defRPr sz="395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DB5E8-7F1D-4D4A-BF31-59CD61463A2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9423D-0300-4726-B9C6-00DF37BC2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99908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485460" y="2721714"/>
            <a:ext cx="31181219" cy="98809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85460" y="13608513"/>
            <a:ext cx="31181219" cy="3243559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485460" y="47381303"/>
            <a:ext cx="8134231" cy="27217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74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8DB5E8-7F1D-4D4A-BF31-59CD61463A2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1975396" y="47381303"/>
            <a:ext cx="12201347" cy="27217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74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5532447" y="47381303"/>
            <a:ext cx="8134231" cy="27217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74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9423D-0300-4726-B9C6-00DF37BC2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3723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3615172" rtl="0" eaLnBrk="1" latinLnBrk="0" hangingPunct="1">
        <a:lnSpc>
          <a:spcPct val="90000"/>
        </a:lnSpc>
        <a:spcBef>
          <a:spcPct val="0"/>
        </a:spcBef>
        <a:buNone/>
        <a:defRPr kumimoji="1" sz="1739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03793" indent="-903793" algn="l" defTabSz="3615172" rtl="0" eaLnBrk="1" latinLnBrk="0" hangingPunct="1">
        <a:lnSpc>
          <a:spcPct val="90000"/>
        </a:lnSpc>
        <a:spcBef>
          <a:spcPts val="3954"/>
        </a:spcBef>
        <a:buFont typeface="Arial" panose="020B0604020202020204" pitchFamily="34" charset="0"/>
        <a:buChar char="•"/>
        <a:defRPr kumimoji="1" sz="11070" kern="1200">
          <a:solidFill>
            <a:schemeClr val="tx1"/>
          </a:solidFill>
          <a:latin typeface="+mn-lt"/>
          <a:ea typeface="+mn-ea"/>
          <a:cs typeface="+mn-cs"/>
        </a:defRPr>
      </a:lvl1pPr>
      <a:lvl2pPr marL="2711379" indent="-903793" algn="l" defTabSz="3615172" rtl="0" eaLnBrk="1" latinLnBrk="0" hangingPunct="1">
        <a:lnSpc>
          <a:spcPct val="90000"/>
        </a:lnSpc>
        <a:spcBef>
          <a:spcPts val="1977"/>
        </a:spcBef>
        <a:buFont typeface="Arial" panose="020B0604020202020204" pitchFamily="34" charset="0"/>
        <a:buChar char="•"/>
        <a:defRPr kumimoji="1" sz="9489" kern="1200">
          <a:solidFill>
            <a:schemeClr val="tx1"/>
          </a:solidFill>
          <a:latin typeface="+mn-lt"/>
          <a:ea typeface="+mn-ea"/>
          <a:cs typeface="+mn-cs"/>
        </a:defRPr>
      </a:lvl2pPr>
      <a:lvl3pPr marL="4518965" indent="-903793" algn="l" defTabSz="3615172" rtl="0" eaLnBrk="1" latinLnBrk="0" hangingPunct="1">
        <a:lnSpc>
          <a:spcPct val="90000"/>
        </a:lnSpc>
        <a:spcBef>
          <a:spcPts val="1977"/>
        </a:spcBef>
        <a:buFont typeface="Arial" panose="020B0604020202020204" pitchFamily="34" charset="0"/>
        <a:buChar char="•"/>
        <a:defRPr kumimoji="1" sz="7907" kern="1200">
          <a:solidFill>
            <a:schemeClr val="tx1"/>
          </a:solidFill>
          <a:latin typeface="+mn-lt"/>
          <a:ea typeface="+mn-ea"/>
          <a:cs typeface="+mn-cs"/>
        </a:defRPr>
      </a:lvl3pPr>
      <a:lvl4pPr marL="6326551" indent="-903793" algn="l" defTabSz="3615172" rtl="0" eaLnBrk="1" latinLnBrk="0" hangingPunct="1">
        <a:lnSpc>
          <a:spcPct val="90000"/>
        </a:lnSpc>
        <a:spcBef>
          <a:spcPts val="1977"/>
        </a:spcBef>
        <a:buFont typeface="Arial" panose="020B0604020202020204" pitchFamily="34" charset="0"/>
        <a:buChar char="•"/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4pPr>
      <a:lvl5pPr marL="8134137" indent="-903793" algn="l" defTabSz="3615172" rtl="0" eaLnBrk="1" latinLnBrk="0" hangingPunct="1">
        <a:lnSpc>
          <a:spcPct val="90000"/>
        </a:lnSpc>
        <a:spcBef>
          <a:spcPts val="1977"/>
        </a:spcBef>
        <a:buFont typeface="Arial" panose="020B0604020202020204" pitchFamily="34" charset="0"/>
        <a:buChar char="•"/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5pPr>
      <a:lvl6pPr marL="9941723" indent="-903793" algn="l" defTabSz="3615172" rtl="0" eaLnBrk="1" latinLnBrk="0" hangingPunct="1">
        <a:lnSpc>
          <a:spcPct val="90000"/>
        </a:lnSpc>
        <a:spcBef>
          <a:spcPts val="1977"/>
        </a:spcBef>
        <a:buFont typeface="Arial" panose="020B0604020202020204" pitchFamily="34" charset="0"/>
        <a:buChar char="•"/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6pPr>
      <a:lvl7pPr marL="11749308" indent="-903793" algn="l" defTabSz="3615172" rtl="0" eaLnBrk="1" latinLnBrk="0" hangingPunct="1">
        <a:lnSpc>
          <a:spcPct val="90000"/>
        </a:lnSpc>
        <a:spcBef>
          <a:spcPts val="1977"/>
        </a:spcBef>
        <a:buFont typeface="Arial" panose="020B0604020202020204" pitchFamily="34" charset="0"/>
        <a:buChar char="•"/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7pPr>
      <a:lvl8pPr marL="13556894" indent="-903793" algn="l" defTabSz="3615172" rtl="0" eaLnBrk="1" latinLnBrk="0" hangingPunct="1">
        <a:lnSpc>
          <a:spcPct val="90000"/>
        </a:lnSpc>
        <a:spcBef>
          <a:spcPts val="1977"/>
        </a:spcBef>
        <a:buFont typeface="Arial" panose="020B0604020202020204" pitchFamily="34" charset="0"/>
        <a:buChar char="•"/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8pPr>
      <a:lvl9pPr marL="15364480" indent="-903793" algn="l" defTabSz="3615172" rtl="0" eaLnBrk="1" latinLnBrk="0" hangingPunct="1">
        <a:lnSpc>
          <a:spcPct val="90000"/>
        </a:lnSpc>
        <a:spcBef>
          <a:spcPts val="1977"/>
        </a:spcBef>
        <a:buFont typeface="Arial" panose="020B0604020202020204" pitchFamily="34" charset="0"/>
        <a:buChar char="•"/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615172" rtl="0" eaLnBrk="1" latinLnBrk="0" hangingPunct="1"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1pPr>
      <a:lvl2pPr marL="1807586" algn="l" defTabSz="3615172" rtl="0" eaLnBrk="1" latinLnBrk="0" hangingPunct="1"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2pPr>
      <a:lvl3pPr marL="3615172" algn="l" defTabSz="3615172" rtl="0" eaLnBrk="1" latinLnBrk="0" hangingPunct="1"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3pPr>
      <a:lvl4pPr marL="5422758" algn="l" defTabSz="3615172" rtl="0" eaLnBrk="1" latinLnBrk="0" hangingPunct="1"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4pPr>
      <a:lvl5pPr marL="7230344" algn="l" defTabSz="3615172" rtl="0" eaLnBrk="1" latinLnBrk="0" hangingPunct="1"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5pPr>
      <a:lvl6pPr marL="9037930" algn="l" defTabSz="3615172" rtl="0" eaLnBrk="1" latinLnBrk="0" hangingPunct="1"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6pPr>
      <a:lvl7pPr marL="10845516" algn="l" defTabSz="3615172" rtl="0" eaLnBrk="1" latinLnBrk="0" hangingPunct="1"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7pPr>
      <a:lvl8pPr marL="12653101" algn="l" defTabSz="3615172" rtl="0" eaLnBrk="1" latinLnBrk="0" hangingPunct="1"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8pPr>
      <a:lvl9pPr marL="14460687" algn="l" defTabSz="3615172" rtl="0" eaLnBrk="1" latinLnBrk="0" hangingPunct="1"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jp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8CE57DFA-51F5-4B7F-B7DC-4E6B4F484F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83381" y="4208294"/>
            <a:ext cx="14816546" cy="14816546"/>
          </a:xfrm>
          <a:prstGeom prst="rect">
            <a:avLst/>
          </a:prstGeom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D0D85A05-C3DE-47B4-BE8E-AE65831F33DA}"/>
              </a:ext>
            </a:extLst>
          </p:cNvPr>
          <p:cNvSpPr/>
          <p:nvPr/>
        </p:nvSpPr>
        <p:spPr>
          <a:xfrm>
            <a:off x="214507" y="171389"/>
            <a:ext cx="11703845" cy="228280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endParaRPr lang="en-US" altLang="ja-JP" sz="7117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7117" b="1" dirty="0">
                <a:latin typeface="Arial" panose="020B0604020202020204" pitchFamily="34" charset="0"/>
                <a:cs typeface="Arial" panose="020B0604020202020204" pitchFamily="34" charset="0"/>
              </a:rPr>
              <a:t>   Supplementary FigureS1</a:t>
            </a:r>
            <a:endParaRPr lang="ja-JP" altLang="en-US" sz="7117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109550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BF348815-BDAE-456A-B69B-71E536485970}"/>
              </a:ext>
            </a:extLst>
          </p:cNvPr>
          <p:cNvGrpSpPr/>
          <p:nvPr/>
        </p:nvGrpSpPr>
        <p:grpSpPr>
          <a:xfrm>
            <a:off x="6508133" y="5462451"/>
            <a:ext cx="23405810" cy="6522720"/>
            <a:chOff x="323602" y="251050"/>
            <a:chExt cx="5490172" cy="1415906"/>
          </a:xfrm>
        </p:grpSpPr>
        <p:grpSp>
          <p:nvGrpSpPr>
            <p:cNvPr id="9" name="グループ化 8">
              <a:extLst>
                <a:ext uri="{FF2B5EF4-FFF2-40B4-BE49-F238E27FC236}">
                  <a16:creationId xmlns:a16="http://schemas.microsoft.com/office/drawing/2014/main" id="{6CE9824B-C3C6-410C-B99D-EE6CE7A5A1A5}"/>
                </a:ext>
              </a:extLst>
            </p:cNvPr>
            <p:cNvGrpSpPr/>
            <p:nvPr/>
          </p:nvGrpSpPr>
          <p:grpSpPr>
            <a:xfrm>
              <a:off x="323602" y="251050"/>
              <a:ext cx="5490172" cy="1415906"/>
              <a:chOff x="101198" y="95932"/>
              <a:chExt cx="5490172" cy="1415906"/>
            </a:xfrm>
          </p:grpSpPr>
          <p:sp>
            <p:nvSpPr>
              <p:cNvPr id="8" name="矢印: 右 7">
                <a:extLst>
                  <a:ext uri="{FF2B5EF4-FFF2-40B4-BE49-F238E27FC236}">
                    <a16:creationId xmlns:a16="http://schemas.microsoft.com/office/drawing/2014/main" id="{7BB3BE0A-1098-4A8C-9D74-C28302F6F500}"/>
                  </a:ext>
                </a:extLst>
              </p:cNvPr>
              <p:cNvSpPr/>
              <p:nvPr/>
            </p:nvSpPr>
            <p:spPr>
              <a:xfrm>
                <a:off x="101198" y="1164930"/>
                <a:ext cx="5040149" cy="346908"/>
              </a:xfrm>
              <a:prstGeom prst="rightArrow">
                <a:avLst/>
              </a:prstGeom>
              <a:gradFill flip="none" rotWithShape="1">
                <a:gsLst>
                  <a:gs pos="0">
                    <a:schemeClr val="accent1">
                      <a:tint val="66000"/>
                      <a:satMod val="160000"/>
                    </a:schemeClr>
                  </a:gs>
                  <a:gs pos="50000">
                    <a:schemeClr val="accent1">
                      <a:tint val="44500"/>
                      <a:satMod val="160000"/>
                    </a:schemeClr>
                  </a:gs>
                  <a:gs pos="100000">
                    <a:schemeClr val="accent1">
                      <a:tint val="23500"/>
                      <a:satMod val="160000"/>
                    </a:schemeClr>
                  </a:gs>
                </a:gsLst>
                <a:lin ang="10800000" scaled="1"/>
                <a:tileRect/>
              </a:gra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117" dirty="0"/>
              </a:p>
            </p:txBody>
          </p:sp>
          <p:grpSp>
            <p:nvGrpSpPr>
              <p:cNvPr id="15" name="グループ化 14">
                <a:extLst>
                  <a:ext uri="{FF2B5EF4-FFF2-40B4-BE49-F238E27FC236}">
                    <a16:creationId xmlns:a16="http://schemas.microsoft.com/office/drawing/2014/main" id="{E54DC971-6215-4FA8-9E4E-628AA3C25908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79586" y="603896"/>
                <a:ext cx="389891" cy="558729"/>
                <a:chOff x="518720" y="768374"/>
                <a:chExt cx="753370" cy="1206449"/>
              </a:xfrm>
            </p:grpSpPr>
            <p:sp>
              <p:nvSpPr>
                <p:cNvPr id="12" name="楕円 11">
                  <a:extLst>
                    <a:ext uri="{FF2B5EF4-FFF2-40B4-BE49-F238E27FC236}">
                      <a16:creationId xmlns:a16="http://schemas.microsoft.com/office/drawing/2014/main" id="{3E6F2858-02A1-4350-AD86-2B1769492C4B}"/>
                    </a:ext>
                  </a:extLst>
                </p:cNvPr>
                <p:cNvSpPr/>
                <p:nvPr/>
              </p:nvSpPr>
              <p:spPr>
                <a:xfrm>
                  <a:off x="611634" y="827584"/>
                  <a:ext cx="504056" cy="792088"/>
                </a:xfrm>
                <a:prstGeom prst="ellipse">
                  <a:avLst/>
                </a:prstGeom>
                <a:noFill/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117"/>
                </a:p>
              </p:txBody>
            </p:sp>
            <p:sp>
              <p:nvSpPr>
                <p:cNvPr id="13" name="フリーフォーム: 図形 12">
                  <a:extLst>
                    <a:ext uri="{FF2B5EF4-FFF2-40B4-BE49-F238E27FC236}">
                      <a16:creationId xmlns:a16="http://schemas.microsoft.com/office/drawing/2014/main" id="{DDB4056A-BE29-4061-9335-98134580062D}"/>
                    </a:ext>
                  </a:extLst>
                </p:cNvPr>
                <p:cNvSpPr/>
                <p:nvPr/>
              </p:nvSpPr>
              <p:spPr>
                <a:xfrm>
                  <a:off x="863662" y="1619672"/>
                  <a:ext cx="408428" cy="355151"/>
                </a:xfrm>
                <a:custGeom>
                  <a:avLst/>
                  <a:gdLst>
                    <a:gd name="connsiteX0" fmla="*/ 51322 w 408428"/>
                    <a:gd name="connsiteY0" fmla="*/ 0 h 355151"/>
                    <a:gd name="connsiteX1" fmla="*/ 23187 w 408428"/>
                    <a:gd name="connsiteY1" fmla="*/ 253218 h 355151"/>
                    <a:gd name="connsiteX2" fmla="*/ 346743 w 408428"/>
                    <a:gd name="connsiteY2" fmla="*/ 112541 h 355151"/>
                    <a:gd name="connsiteX3" fmla="*/ 403014 w 408428"/>
                    <a:gd name="connsiteY3" fmla="*/ 337624 h 355151"/>
                    <a:gd name="connsiteX4" fmla="*/ 403014 w 408428"/>
                    <a:gd name="connsiteY4" fmla="*/ 323557 h 35515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408428" h="355151">
                      <a:moveTo>
                        <a:pt x="51322" y="0"/>
                      </a:moveTo>
                      <a:cubicBezTo>
                        <a:pt x="12636" y="117230"/>
                        <a:pt x="-26050" y="234461"/>
                        <a:pt x="23187" y="253218"/>
                      </a:cubicBezTo>
                      <a:cubicBezTo>
                        <a:pt x="72424" y="271975"/>
                        <a:pt x="283439" y="98473"/>
                        <a:pt x="346743" y="112541"/>
                      </a:cubicBezTo>
                      <a:cubicBezTo>
                        <a:pt x="410048" y="126609"/>
                        <a:pt x="393636" y="302455"/>
                        <a:pt x="403014" y="337624"/>
                      </a:cubicBezTo>
                      <a:cubicBezTo>
                        <a:pt x="412392" y="372793"/>
                        <a:pt x="407703" y="348175"/>
                        <a:pt x="403014" y="323557"/>
                      </a:cubicBezTo>
                    </a:path>
                  </a:pathLst>
                </a:custGeom>
                <a:noFill/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117"/>
                </a:p>
              </p:txBody>
            </p:sp>
            <p:sp>
              <p:nvSpPr>
                <p:cNvPr id="14" name="弦 13">
                  <a:extLst>
                    <a:ext uri="{FF2B5EF4-FFF2-40B4-BE49-F238E27FC236}">
                      <a16:creationId xmlns:a16="http://schemas.microsoft.com/office/drawing/2014/main" id="{ADD9E229-3D33-4E28-A5CE-70BBB14DF18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3677515">
                  <a:off x="518720" y="768374"/>
                  <a:ext cx="249694" cy="249694"/>
                </a:xfrm>
                <a:prstGeom prst="chord">
                  <a:avLst/>
                </a:prstGeom>
                <a:noFill/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117"/>
                </a:p>
              </p:txBody>
            </p:sp>
            <p:sp>
              <p:nvSpPr>
                <p:cNvPr id="17" name="弦 16">
                  <a:extLst>
                    <a:ext uri="{FF2B5EF4-FFF2-40B4-BE49-F238E27FC236}">
                      <a16:creationId xmlns:a16="http://schemas.microsoft.com/office/drawing/2014/main" id="{AC4D5C08-2031-4DCC-9513-4DD96A8B3F5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0402476">
                  <a:off x="974671" y="802027"/>
                  <a:ext cx="256032" cy="256032"/>
                </a:xfrm>
                <a:prstGeom prst="chord">
                  <a:avLst/>
                </a:prstGeom>
                <a:noFill/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117"/>
                </a:p>
              </p:txBody>
            </p:sp>
          </p:grpSp>
          <p:sp>
            <p:nvSpPr>
              <p:cNvPr id="18" name="テキスト ボックス 17">
                <a:extLst>
                  <a:ext uri="{FF2B5EF4-FFF2-40B4-BE49-F238E27FC236}">
                    <a16:creationId xmlns:a16="http://schemas.microsoft.com/office/drawing/2014/main" id="{F550D3FB-138B-490C-B840-82BDD839C56A}"/>
                  </a:ext>
                </a:extLst>
              </p:cNvPr>
              <p:cNvSpPr txBox="1"/>
              <p:nvPr/>
            </p:nvSpPr>
            <p:spPr>
              <a:xfrm>
                <a:off x="545626" y="113343"/>
                <a:ext cx="824322" cy="3464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151" dirty="0">
                    <a:latin typeface="Arial" panose="020B0604020202020204" pitchFamily="34" charset="0"/>
                    <a:cs typeface="Arial" panose="020B0604020202020204" pitchFamily="34" charset="0"/>
                  </a:rPr>
                  <a:t>Transplant </a:t>
                </a:r>
              </a:p>
              <a:p>
                <a:r>
                  <a:rPr kumimoji="1" lang="en-US" altLang="ja-JP" sz="4151" dirty="0">
                    <a:latin typeface="Arial" panose="020B0604020202020204" pitchFamily="34" charset="0"/>
                    <a:cs typeface="Arial" panose="020B0604020202020204" pitchFamily="34" charset="0"/>
                  </a:rPr>
                  <a:t>MKN1</a:t>
                </a:r>
              </a:p>
            </p:txBody>
          </p:sp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5BCA5ABF-5F65-4ECF-92CE-68161013706B}"/>
                  </a:ext>
                </a:extLst>
              </p:cNvPr>
              <p:cNvSpPr txBox="1"/>
              <p:nvPr/>
            </p:nvSpPr>
            <p:spPr>
              <a:xfrm>
                <a:off x="1516057" y="133051"/>
                <a:ext cx="713206" cy="5080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4151" dirty="0">
                    <a:latin typeface="Arial" panose="020B0604020202020204" pitchFamily="34" charset="0"/>
                    <a:cs typeface="Arial" panose="020B0604020202020204" pitchFamily="34" charset="0"/>
                  </a:rPr>
                  <a:t>Collect </a:t>
                </a:r>
              </a:p>
              <a:p>
                <a:r>
                  <a:rPr lang="en-US" altLang="ja-JP" sz="4151" dirty="0">
                    <a:latin typeface="Arial" panose="020B0604020202020204" pitchFamily="34" charset="0"/>
                    <a:cs typeface="Arial" panose="020B0604020202020204" pitchFamily="34" charset="0"/>
                  </a:rPr>
                  <a:t>tumor</a:t>
                </a:r>
                <a:endParaRPr kumimoji="1" lang="en-US" altLang="ja-JP" sz="415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kumimoji="1" lang="en-US" altLang="ja-JP" sz="415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542D794C-1BD2-4A6A-AE06-2985DFA339C6}"/>
                  </a:ext>
                </a:extLst>
              </p:cNvPr>
              <p:cNvSpPr txBox="1"/>
              <p:nvPr/>
            </p:nvSpPr>
            <p:spPr>
              <a:xfrm>
                <a:off x="3986367" y="447778"/>
                <a:ext cx="874185" cy="5080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151" dirty="0">
                    <a:latin typeface="Arial" panose="020B0604020202020204" pitchFamily="34" charset="0"/>
                    <a:cs typeface="Arial" panose="020B0604020202020204" pitchFamily="34" charset="0"/>
                  </a:rPr>
                  <a:t>RNA </a:t>
                </a:r>
              </a:p>
              <a:p>
                <a:r>
                  <a:rPr kumimoji="1" lang="en-US" altLang="ja-JP" sz="4151" dirty="0">
                    <a:latin typeface="Arial" panose="020B0604020202020204" pitchFamily="34" charset="0"/>
                    <a:cs typeface="Arial" panose="020B0604020202020204" pitchFamily="34" charset="0"/>
                  </a:rPr>
                  <a:t>extraction</a:t>
                </a:r>
              </a:p>
              <a:p>
                <a:endParaRPr kumimoji="1" lang="en-US" altLang="ja-JP" sz="415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6" name="グループ化 35">
                <a:extLst>
                  <a:ext uri="{FF2B5EF4-FFF2-40B4-BE49-F238E27FC236}">
                    <a16:creationId xmlns:a16="http://schemas.microsoft.com/office/drawing/2014/main" id="{12996330-E999-4905-9746-5FE8C95E412C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634282" y="613141"/>
                <a:ext cx="383393" cy="549417"/>
                <a:chOff x="1979786" y="991835"/>
                <a:chExt cx="660456" cy="931215"/>
              </a:xfrm>
            </p:grpSpPr>
            <p:grpSp>
              <p:nvGrpSpPr>
                <p:cNvPr id="37" name="グループ化 36">
                  <a:extLst>
                    <a:ext uri="{FF2B5EF4-FFF2-40B4-BE49-F238E27FC236}">
                      <a16:creationId xmlns:a16="http://schemas.microsoft.com/office/drawing/2014/main" id="{DA9453B0-0FB8-406F-A61F-D469B834E9A2}"/>
                    </a:ext>
                  </a:extLst>
                </p:cNvPr>
                <p:cNvGrpSpPr/>
                <p:nvPr/>
              </p:nvGrpSpPr>
              <p:grpSpPr>
                <a:xfrm>
                  <a:off x="1979786" y="991835"/>
                  <a:ext cx="660456" cy="931215"/>
                  <a:chOff x="518720" y="768374"/>
                  <a:chExt cx="753370" cy="1206449"/>
                </a:xfrm>
              </p:grpSpPr>
              <p:sp>
                <p:nvSpPr>
                  <p:cNvPr id="39" name="楕円 38">
                    <a:extLst>
                      <a:ext uri="{FF2B5EF4-FFF2-40B4-BE49-F238E27FC236}">
                        <a16:creationId xmlns:a16="http://schemas.microsoft.com/office/drawing/2014/main" id="{311CA55F-FD60-4AE7-909A-8F1B87BF6533}"/>
                      </a:ext>
                    </a:extLst>
                  </p:cNvPr>
                  <p:cNvSpPr/>
                  <p:nvPr/>
                </p:nvSpPr>
                <p:spPr>
                  <a:xfrm>
                    <a:off x="611634" y="827584"/>
                    <a:ext cx="504056" cy="792088"/>
                  </a:xfrm>
                  <a:prstGeom prst="ellipse">
                    <a:avLst/>
                  </a:prstGeom>
                  <a:noFill/>
                  <a:ln w="285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7117"/>
                  </a:p>
                </p:txBody>
              </p:sp>
              <p:sp>
                <p:nvSpPr>
                  <p:cNvPr id="40" name="フリーフォーム: 図形 39">
                    <a:extLst>
                      <a:ext uri="{FF2B5EF4-FFF2-40B4-BE49-F238E27FC236}">
                        <a16:creationId xmlns:a16="http://schemas.microsoft.com/office/drawing/2014/main" id="{5621DBF1-EE29-4751-A740-8464E03952FF}"/>
                      </a:ext>
                    </a:extLst>
                  </p:cNvPr>
                  <p:cNvSpPr/>
                  <p:nvPr/>
                </p:nvSpPr>
                <p:spPr>
                  <a:xfrm>
                    <a:off x="863662" y="1619672"/>
                    <a:ext cx="408428" cy="355151"/>
                  </a:xfrm>
                  <a:custGeom>
                    <a:avLst/>
                    <a:gdLst>
                      <a:gd name="connsiteX0" fmla="*/ 51322 w 408428"/>
                      <a:gd name="connsiteY0" fmla="*/ 0 h 355151"/>
                      <a:gd name="connsiteX1" fmla="*/ 23187 w 408428"/>
                      <a:gd name="connsiteY1" fmla="*/ 253218 h 355151"/>
                      <a:gd name="connsiteX2" fmla="*/ 346743 w 408428"/>
                      <a:gd name="connsiteY2" fmla="*/ 112541 h 355151"/>
                      <a:gd name="connsiteX3" fmla="*/ 403014 w 408428"/>
                      <a:gd name="connsiteY3" fmla="*/ 337624 h 355151"/>
                      <a:gd name="connsiteX4" fmla="*/ 403014 w 408428"/>
                      <a:gd name="connsiteY4" fmla="*/ 323557 h 355151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</a:cxnLst>
                    <a:rect l="l" t="t" r="r" b="b"/>
                    <a:pathLst>
                      <a:path w="408428" h="355151">
                        <a:moveTo>
                          <a:pt x="51322" y="0"/>
                        </a:moveTo>
                        <a:cubicBezTo>
                          <a:pt x="12636" y="117230"/>
                          <a:pt x="-26050" y="234461"/>
                          <a:pt x="23187" y="253218"/>
                        </a:cubicBezTo>
                        <a:cubicBezTo>
                          <a:pt x="72424" y="271975"/>
                          <a:pt x="283439" y="98473"/>
                          <a:pt x="346743" y="112541"/>
                        </a:cubicBezTo>
                        <a:cubicBezTo>
                          <a:pt x="410048" y="126609"/>
                          <a:pt x="393636" y="302455"/>
                          <a:pt x="403014" y="337624"/>
                        </a:cubicBezTo>
                        <a:cubicBezTo>
                          <a:pt x="412392" y="372793"/>
                          <a:pt x="407703" y="348175"/>
                          <a:pt x="403014" y="323557"/>
                        </a:cubicBezTo>
                      </a:path>
                    </a:pathLst>
                  </a:custGeom>
                  <a:noFill/>
                  <a:ln w="285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7117"/>
                  </a:p>
                </p:txBody>
              </p:sp>
              <p:sp>
                <p:nvSpPr>
                  <p:cNvPr id="41" name="弦 40">
                    <a:extLst>
                      <a:ext uri="{FF2B5EF4-FFF2-40B4-BE49-F238E27FC236}">
                        <a16:creationId xmlns:a16="http://schemas.microsoft.com/office/drawing/2014/main" id="{3C8553B1-866B-482F-89D6-D3D9F369D7A0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677515">
                    <a:off x="518720" y="768374"/>
                    <a:ext cx="249694" cy="249694"/>
                  </a:xfrm>
                  <a:prstGeom prst="chord">
                    <a:avLst/>
                  </a:prstGeom>
                  <a:noFill/>
                  <a:ln w="285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7117"/>
                  </a:p>
                </p:txBody>
              </p:sp>
              <p:sp>
                <p:nvSpPr>
                  <p:cNvPr id="42" name="弦 41">
                    <a:extLst>
                      <a:ext uri="{FF2B5EF4-FFF2-40B4-BE49-F238E27FC236}">
                        <a16:creationId xmlns:a16="http://schemas.microsoft.com/office/drawing/2014/main" id="{5498E01D-8A38-41A4-AF2F-E3FDDF740A2E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0402476">
                    <a:off x="974671" y="802027"/>
                    <a:ext cx="256032" cy="256032"/>
                  </a:xfrm>
                  <a:prstGeom prst="chord">
                    <a:avLst/>
                  </a:prstGeom>
                  <a:noFill/>
                  <a:ln w="285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7117"/>
                  </a:p>
                </p:txBody>
              </p:sp>
            </p:grpSp>
            <p:sp>
              <p:nvSpPr>
                <p:cNvPr id="38" name="楕円 37">
                  <a:extLst>
                    <a:ext uri="{FF2B5EF4-FFF2-40B4-BE49-F238E27FC236}">
                      <a16:creationId xmlns:a16="http://schemas.microsoft.com/office/drawing/2014/main" id="{BA26332E-5C99-427D-A459-585EAA3A20E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6750917">
                  <a:off x="2332613" y="1376212"/>
                  <a:ext cx="178903" cy="117326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117"/>
                </a:p>
              </p:txBody>
            </p:sp>
          </p:grpSp>
          <p:grpSp>
            <p:nvGrpSpPr>
              <p:cNvPr id="67" name="グループ化 66">
                <a:extLst>
                  <a:ext uri="{FF2B5EF4-FFF2-40B4-BE49-F238E27FC236}">
                    <a16:creationId xmlns:a16="http://schemas.microsoft.com/office/drawing/2014/main" id="{1BFEE512-ECA3-478B-AEE9-D6B99ECA0394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655566" y="611707"/>
                <a:ext cx="655394" cy="558729"/>
                <a:chOff x="1955751" y="1025939"/>
                <a:chExt cx="1110202" cy="931215"/>
              </a:xfrm>
            </p:grpSpPr>
            <p:grpSp>
              <p:nvGrpSpPr>
                <p:cNvPr id="29" name="グループ化 28">
                  <a:extLst>
                    <a:ext uri="{FF2B5EF4-FFF2-40B4-BE49-F238E27FC236}">
                      <a16:creationId xmlns:a16="http://schemas.microsoft.com/office/drawing/2014/main" id="{79E0AC01-A0FF-4ADA-9F54-6DED67E3B3D9}"/>
                    </a:ext>
                  </a:extLst>
                </p:cNvPr>
                <p:cNvGrpSpPr/>
                <p:nvPr/>
              </p:nvGrpSpPr>
              <p:grpSpPr>
                <a:xfrm>
                  <a:off x="1955751" y="1025939"/>
                  <a:ext cx="660456" cy="931215"/>
                  <a:chOff x="518720" y="768374"/>
                  <a:chExt cx="753370" cy="1206449"/>
                </a:xfrm>
              </p:grpSpPr>
              <p:sp>
                <p:nvSpPr>
                  <p:cNvPr id="30" name="楕円 29">
                    <a:extLst>
                      <a:ext uri="{FF2B5EF4-FFF2-40B4-BE49-F238E27FC236}">
                        <a16:creationId xmlns:a16="http://schemas.microsoft.com/office/drawing/2014/main" id="{483C912F-81A4-4DE7-AF72-E4665C16B4A6}"/>
                      </a:ext>
                    </a:extLst>
                  </p:cNvPr>
                  <p:cNvSpPr/>
                  <p:nvPr/>
                </p:nvSpPr>
                <p:spPr>
                  <a:xfrm>
                    <a:off x="611634" y="827584"/>
                    <a:ext cx="504056" cy="792088"/>
                  </a:xfrm>
                  <a:prstGeom prst="ellipse">
                    <a:avLst/>
                  </a:prstGeom>
                  <a:noFill/>
                  <a:ln w="285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7117"/>
                  </a:p>
                </p:txBody>
              </p:sp>
              <p:sp>
                <p:nvSpPr>
                  <p:cNvPr id="31" name="フリーフォーム: 図形 30">
                    <a:extLst>
                      <a:ext uri="{FF2B5EF4-FFF2-40B4-BE49-F238E27FC236}">
                        <a16:creationId xmlns:a16="http://schemas.microsoft.com/office/drawing/2014/main" id="{4C78EC35-C8D8-4261-960A-D51FB5C7F59D}"/>
                      </a:ext>
                    </a:extLst>
                  </p:cNvPr>
                  <p:cNvSpPr/>
                  <p:nvPr/>
                </p:nvSpPr>
                <p:spPr>
                  <a:xfrm>
                    <a:off x="863662" y="1619672"/>
                    <a:ext cx="408428" cy="355151"/>
                  </a:xfrm>
                  <a:custGeom>
                    <a:avLst/>
                    <a:gdLst>
                      <a:gd name="connsiteX0" fmla="*/ 51322 w 408428"/>
                      <a:gd name="connsiteY0" fmla="*/ 0 h 355151"/>
                      <a:gd name="connsiteX1" fmla="*/ 23187 w 408428"/>
                      <a:gd name="connsiteY1" fmla="*/ 253218 h 355151"/>
                      <a:gd name="connsiteX2" fmla="*/ 346743 w 408428"/>
                      <a:gd name="connsiteY2" fmla="*/ 112541 h 355151"/>
                      <a:gd name="connsiteX3" fmla="*/ 403014 w 408428"/>
                      <a:gd name="connsiteY3" fmla="*/ 337624 h 355151"/>
                      <a:gd name="connsiteX4" fmla="*/ 403014 w 408428"/>
                      <a:gd name="connsiteY4" fmla="*/ 323557 h 355151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</a:cxnLst>
                    <a:rect l="l" t="t" r="r" b="b"/>
                    <a:pathLst>
                      <a:path w="408428" h="355151">
                        <a:moveTo>
                          <a:pt x="51322" y="0"/>
                        </a:moveTo>
                        <a:cubicBezTo>
                          <a:pt x="12636" y="117230"/>
                          <a:pt x="-26050" y="234461"/>
                          <a:pt x="23187" y="253218"/>
                        </a:cubicBezTo>
                        <a:cubicBezTo>
                          <a:pt x="72424" y="271975"/>
                          <a:pt x="283439" y="98473"/>
                          <a:pt x="346743" y="112541"/>
                        </a:cubicBezTo>
                        <a:cubicBezTo>
                          <a:pt x="410048" y="126609"/>
                          <a:pt x="393636" y="302455"/>
                          <a:pt x="403014" y="337624"/>
                        </a:cubicBezTo>
                        <a:cubicBezTo>
                          <a:pt x="412392" y="372793"/>
                          <a:pt x="407703" y="348175"/>
                          <a:pt x="403014" y="323557"/>
                        </a:cubicBezTo>
                      </a:path>
                    </a:pathLst>
                  </a:custGeom>
                  <a:noFill/>
                  <a:ln w="285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7117"/>
                  </a:p>
                </p:txBody>
              </p:sp>
              <p:sp>
                <p:nvSpPr>
                  <p:cNvPr id="32" name="弦 31">
                    <a:extLst>
                      <a:ext uri="{FF2B5EF4-FFF2-40B4-BE49-F238E27FC236}">
                        <a16:creationId xmlns:a16="http://schemas.microsoft.com/office/drawing/2014/main" id="{9C8CE2B0-2CB1-426D-B660-27A912ACDBC2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3677515">
                    <a:off x="518720" y="768374"/>
                    <a:ext cx="249694" cy="249694"/>
                  </a:xfrm>
                  <a:prstGeom prst="chord">
                    <a:avLst/>
                  </a:prstGeom>
                  <a:noFill/>
                  <a:ln w="285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7117"/>
                  </a:p>
                </p:txBody>
              </p:sp>
              <p:sp>
                <p:nvSpPr>
                  <p:cNvPr id="33" name="弦 32">
                    <a:extLst>
                      <a:ext uri="{FF2B5EF4-FFF2-40B4-BE49-F238E27FC236}">
                        <a16:creationId xmlns:a16="http://schemas.microsoft.com/office/drawing/2014/main" id="{7722DF8F-B932-4A23-B592-C01764A9BBE2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0402476">
                    <a:off x="974671" y="802027"/>
                    <a:ext cx="256032" cy="256032"/>
                  </a:xfrm>
                  <a:prstGeom prst="chord">
                    <a:avLst/>
                  </a:prstGeom>
                  <a:noFill/>
                  <a:ln w="285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7117"/>
                  </a:p>
                </p:txBody>
              </p:sp>
            </p:grpSp>
            <p:sp>
              <p:nvSpPr>
                <p:cNvPr id="34" name="楕円 33">
                  <a:extLst>
                    <a:ext uri="{FF2B5EF4-FFF2-40B4-BE49-F238E27FC236}">
                      <a16:creationId xmlns:a16="http://schemas.microsoft.com/office/drawing/2014/main" id="{02988559-039B-4858-8E3F-6CC8CEA0D34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6750917">
                  <a:off x="2340080" y="1491471"/>
                  <a:ext cx="73396" cy="48134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117"/>
                </a:p>
              </p:txBody>
            </p:sp>
            <p:grpSp>
              <p:nvGrpSpPr>
                <p:cNvPr id="66" name="グループ化 65">
                  <a:extLst>
                    <a:ext uri="{FF2B5EF4-FFF2-40B4-BE49-F238E27FC236}">
                      <a16:creationId xmlns:a16="http://schemas.microsoft.com/office/drawing/2014/main" id="{33E4EC89-76D4-4B2D-95E9-496BE47134D6}"/>
                    </a:ext>
                  </a:extLst>
                </p:cNvPr>
                <p:cNvGrpSpPr/>
                <p:nvPr/>
              </p:nvGrpSpPr>
              <p:grpSpPr>
                <a:xfrm rot="1761854">
                  <a:off x="2494372" y="1658583"/>
                  <a:ext cx="571581" cy="125095"/>
                  <a:chOff x="3941897" y="2224342"/>
                  <a:chExt cx="1362103" cy="259426"/>
                </a:xfrm>
              </p:grpSpPr>
              <p:sp>
                <p:nvSpPr>
                  <p:cNvPr id="44" name="正方形/長方形 43">
                    <a:extLst>
                      <a:ext uri="{FF2B5EF4-FFF2-40B4-BE49-F238E27FC236}">
                        <a16:creationId xmlns:a16="http://schemas.microsoft.com/office/drawing/2014/main" id="{B53687D4-5055-4EB6-B7D2-E6ECECA98B47}"/>
                      </a:ext>
                    </a:extLst>
                  </p:cNvPr>
                  <p:cNvSpPr/>
                  <p:nvPr/>
                </p:nvSpPr>
                <p:spPr>
                  <a:xfrm>
                    <a:off x="4356050" y="2224342"/>
                    <a:ext cx="947950" cy="259426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7117"/>
                  </a:p>
                </p:txBody>
              </p:sp>
              <p:cxnSp>
                <p:nvCxnSpPr>
                  <p:cNvPr id="46" name="直線コネクタ 45">
                    <a:extLst>
                      <a:ext uri="{FF2B5EF4-FFF2-40B4-BE49-F238E27FC236}">
                        <a16:creationId xmlns:a16="http://schemas.microsoft.com/office/drawing/2014/main" id="{CB5CC0F5-FB72-44E2-ACA3-CCCA28103BAA}"/>
                      </a:ext>
                    </a:extLst>
                  </p:cNvPr>
                  <p:cNvCxnSpPr>
                    <a:cxnSpLocks/>
                    <a:stCxn id="44" idx="1"/>
                    <a:endCxn id="44" idx="1"/>
                  </p:cNvCxnSpPr>
                  <p:nvPr/>
                </p:nvCxnSpPr>
                <p:spPr>
                  <a:xfrm>
                    <a:off x="4356050" y="2354055"/>
                    <a:ext cx="0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8" name="直線コネクタ 47">
                    <a:extLst>
                      <a:ext uri="{FF2B5EF4-FFF2-40B4-BE49-F238E27FC236}">
                        <a16:creationId xmlns:a16="http://schemas.microsoft.com/office/drawing/2014/main" id="{F02569AC-6DDB-4472-BB19-56C824F87B0E}"/>
                      </a:ext>
                    </a:extLst>
                  </p:cNvPr>
                  <p:cNvCxnSpPr>
                    <a:cxnSpLocks/>
                    <a:stCxn id="44" idx="1"/>
                    <a:endCxn id="44" idx="1"/>
                  </p:cNvCxnSpPr>
                  <p:nvPr/>
                </p:nvCxnSpPr>
                <p:spPr>
                  <a:xfrm>
                    <a:off x="4356050" y="2354055"/>
                    <a:ext cx="0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8" name="正方形/長方形 57">
                    <a:extLst>
                      <a:ext uri="{FF2B5EF4-FFF2-40B4-BE49-F238E27FC236}">
                        <a16:creationId xmlns:a16="http://schemas.microsoft.com/office/drawing/2014/main" id="{D459BDDE-E39D-499A-9C0D-4A86A4DABDA9}"/>
                      </a:ext>
                    </a:extLst>
                  </p:cNvPr>
                  <p:cNvSpPr/>
                  <p:nvPr/>
                </p:nvSpPr>
                <p:spPr>
                  <a:xfrm>
                    <a:off x="4129430" y="2324957"/>
                    <a:ext cx="215842" cy="86803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7117"/>
                  </a:p>
                </p:txBody>
              </p:sp>
              <p:cxnSp>
                <p:nvCxnSpPr>
                  <p:cNvPr id="64" name="直線コネクタ 63">
                    <a:extLst>
                      <a:ext uri="{FF2B5EF4-FFF2-40B4-BE49-F238E27FC236}">
                        <a16:creationId xmlns:a16="http://schemas.microsoft.com/office/drawing/2014/main" id="{C4036F50-7719-4744-B164-9644B9DFE895}"/>
                      </a:ext>
                    </a:extLst>
                  </p:cNvPr>
                  <p:cNvCxnSpPr>
                    <a:cxnSpLocks/>
                    <a:stCxn id="58" idx="1"/>
                  </p:cNvCxnSpPr>
                  <p:nvPr/>
                </p:nvCxnSpPr>
                <p:spPr>
                  <a:xfrm flipH="1">
                    <a:off x="3941897" y="2368359"/>
                    <a:ext cx="187533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73" name="テキスト ボックス 72">
                <a:extLst>
                  <a:ext uri="{FF2B5EF4-FFF2-40B4-BE49-F238E27FC236}">
                    <a16:creationId xmlns:a16="http://schemas.microsoft.com/office/drawing/2014/main" id="{98081421-4F73-41EB-A8F0-85E9B33F7902}"/>
                  </a:ext>
                </a:extLst>
              </p:cNvPr>
              <p:cNvSpPr txBox="1"/>
              <p:nvPr/>
            </p:nvSpPr>
            <p:spPr>
              <a:xfrm>
                <a:off x="4766481" y="461841"/>
                <a:ext cx="824889" cy="5080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151" dirty="0">
                    <a:latin typeface="Arial" panose="020B0604020202020204" pitchFamily="34" charset="0"/>
                    <a:cs typeface="Arial" panose="020B0604020202020204" pitchFamily="34" charset="0"/>
                  </a:rPr>
                  <a:t>RNA</a:t>
                </a:r>
              </a:p>
              <a:p>
                <a:r>
                  <a:rPr kumimoji="1" lang="en-US" altLang="ja-JP" sz="4151" dirty="0">
                    <a:latin typeface="Arial" panose="020B0604020202020204" pitchFamily="34" charset="0"/>
                    <a:cs typeface="Arial" panose="020B0604020202020204" pitchFamily="34" charset="0"/>
                  </a:rPr>
                  <a:t>sequencing</a:t>
                </a:r>
              </a:p>
              <a:p>
                <a:endParaRPr kumimoji="1" lang="en-US" altLang="ja-JP" sz="415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" name="図 2">
                <a:extLst>
                  <a:ext uri="{FF2B5EF4-FFF2-40B4-BE49-F238E27FC236}">
                    <a16:creationId xmlns:a16="http://schemas.microsoft.com/office/drawing/2014/main" id="{89F77D34-B4D5-4ABC-8D22-65785509997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37479" t="31735" r="25291" b="35056"/>
              <a:stretch/>
            </p:blipFill>
            <p:spPr>
              <a:xfrm>
                <a:off x="2200885" y="95932"/>
                <a:ext cx="1785715" cy="1147187"/>
              </a:xfrm>
              <a:prstGeom prst="rect">
                <a:avLst/>
              </a:prstGeom>
            </p:spPr>
          </p:pic>
          <p:sp>
            <p:nvSpPr>
              <p:cNvPr id="6" name="テキスト ボックス 5">
                <a:extLst>
                  <a:ext uri="{FF2B5EF4-FFF2-40B4-BE49-F238E27FC236}">
                    <a16:creationId xmlns:a16="http://schemas.microsoft.com/office/drawing/2014/main" id="{51E706B8-7ECB-453F-8F6B-1134384777FC}"/>
                  </a:ext>
                </a:extLst>
              </p:cNvPr>
              <p:cNvSpPr txBox="1"/>
              <p:nvPr/>
            </p:nvSpPr>
            <p:spPr>
              <a:xfrm>
                <a:off x="2951560" y="621339"/>
                <a:ext cx="778167" cy="1849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151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igher</a:t>
                </a:r>
                <a:endParaRPr kumimoji="1" lang="ja-JP" altLang="en-US" sz="4151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テキスト ボックス 51">
                <a:extLst>
                  <a:ext uri="{FF2B5EF4-FFF2-40B4-BE49-F238E27FC236}">
                    <a16:creationId xmlns:a16="http://schemas.microsoft.com/office/drawing/2014/main" id="{5D45D2E5-3E7D-4CBF-996F-3A77DF126663}"/>
                  </a:ext>
                </a:extLst>
              </p:cNvPr>
              <p:cNvSpPr txBox="1"/>
              <p:nvPr/>
            </p:nvSpPr>
            <p:spPr>
              <a:xfrm>
                <a:off x="2556321" y="785488"/>
                <a:ext cx="629792" cy="1849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4151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ower</a:t>
                </a:r>
                <a:endParaRPr kumimoji="1" lang="ja-JP" altLang="en-US" sz="4151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テキスト ボックス 46">
                <a:extLst>
                  <a:ext uri="{FF2B5EF4-FFF2-40B4-BE49-F238E27FC236}">
                    <a16:creationId xmlns:a16="http://schemas.microsoft.com/office/drawing/2014/main" id="{FB9E3BE7-BF2C-4C33-A409-EAB7E8A79E0E}"/>
                  </a:ext>
                </a:extLst>
              </p:cNvPr>
              <p:cNvSpPr txBox="1"/>
              <p:nvPr/>
            </p:nvSpPr>
            <p:spPr>
              <a:xfrm>
                <a:off x="2427243" y="269684"/>
                <a:ext cx="565327" cy="18491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4151" dirty="0">
                    <a:latin typeface="Arial" panose="020B0604020202020204" pitchFamily="34" charset="0"/>
                    <a:cs typeface="Arial" panose="020B0604020202020204" pitchFamily="34" charset="0"/>
                  </a:rPr>
                  <a:t>FACS</a:t>
                </a:r>
                <a:endParaRPr kumimoji="1" lang="en-US" altLang="ja-JP" sz="415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008F8EEC-B108-4FAA-8B39-FA32D8900752}"/>
                </a:ext>
              </a:extLst>
            </p:cNvPr>
            <p:cNvSpPr txBox="1"/>
            <p:nvPr/>
          </p:nvSpPr>
          <p:spPr>
            <a:xfrm>
              <a:off x="974735" y="1385034"/>
              <a:ext cx="457022" cy="2080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4745" b="1" dirty="0">
                  <a:latin typeface="Arial" panose="020B0604020202020204" pitchFamily="34" charset="0"/>
                  <a:cs typeface="Arial" panose="020B0604020202020204" pitchFamily="34" charset="0"/>
                </a:rPr>
                <a:t>Day</a:t>
              </a:r>
              <a:r>
                <a:rPr kumimoji="1" lang="ja-JP" altLang="en-US" sz="4745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sz="4745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4745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628B083F-F07F-4907-998B-0EB3FC8E501C}"/>
                </a:ext>
              </a:extLst>
            </p:cNvPr>
            <p:cNvSpPr txBox="1"/>
            <p:nvPr/>
          </p:nvSpPr>
          <p:spPr>
            <a:xfrm>
              <a:off x="1837186" y="1393788"/>
              <a:ext cx="542572" cy="2080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4745" b="1" dirty="0">
                  <a:latin typeface="Arial" panose="020B0604020202020204" pitchFamily="34" charset="0"/>
                  <a:cs typeface="Arial" panose="020B0604020202020204" pitchFamily="34" charset="0"/>
                </a:rPr>
                <a:t>Day 20</a:t>
              </a:r>
              <a:endParaRPr kumimoji="1" lang="ja-JP" altLang="en-US" sz="4745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3C24002-FADC-44EE-82D9-930DB764595C}"/>
              </a:ext>
            </a:extLst>
          </p:cNvPr>
          <p:cNvSpPr txBox="1"/>
          <p:nvPr/>
        </p:nvSpPr>
        <p:spPr>
          <a:xfrm>
            <a:off x="2910896" y="4274882"/>
            <a:ext cx="843501" cy="1187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117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7117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正方形/長方形 42">
            <a:extLst>
              <a:ext uri="{FF2B5EF4-FFF2-40B4-BE49-F238E27FC236}">
                <a16:creationId xmlns:a16="http://schemas.microsoft.com/office/drawing/2014/main" id="{FB98C3AC-0038-456E-AE2D-AAA43E2AE494}"/>
              </a:ext>
            </a:extLst>
          </p:cNvPr>
          <p:cNvSpPr/>
          <p:nvPr/>
        </p:nvSpPr>
        <p:spPr>
          <a:xfrm>
            <a:off x="214507" y="171389"/>
            <a:ext cx="12107802" cy="228280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endParaRPr lang="en-US" altLang="ja-JP" sz="7117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7117" b="1" dirty="0">
                <a:latin typeface="Arial" panose="020B0604020202020204" pitchFamily="34" charset="0"/>
                <a:cs typeface="Arial" panose="020B0604020202020204" pitchFamily="34" charset="0"/>
              </a:rPr>
              <a:t>   Supplementary FigureS2</a:t>
            </a:r>
            <a:endParaRPr lang="ja-JP" altLang="en-US" sz="7117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B592E9BC-A250-4A4C-953C-F3CB942F914F}"/>
              </a:ext>
            </a:extLst>
          </p:cNvPr>
          <p:cNvSpPr txBox="1"/>
          <p:nvPr/>
        </p:nvSpPr>
        <p:spPr>
          <a:xfrm>
            <a:off x="2489146" y="15545026"/>
            <a:ext cx="843501" cy="1187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117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7117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64392F1B-6392-431E-A9B6-5C38C585E3B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974862" y="15356170"/>
            <a:ext cx="12951417" cy="31769478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14B3C159-6F13-4AFA-B53B-CFA160FDAD4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672990" y="48480701"/>
            <a:ext cx="9118020" cy="1481117"/>
          </a:xfrm>
          <a:prstGeom prst="rect">
            <a:avLst/>
          </a:prstGeom>
        </p:spPr>
      </p:pic>
      <p:graphicFrame>
        <p:nvGraphicFramePr>
          <p:cNvPr id="20" name="表 19">
            <a:extLst>
              <a:ext uri="{FF2B5EF4-FFF2-40B4-BE49-F238E27FC236}">
                <a16:creationId xmlns:a16="http://schemas.microsoft.com/office/drawing/2014/main" id="{9DBB50B8-8CE9-4459-A677-294FD500D93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39372474"/>
              </p:ext>
            </p:extLst>
          </p:nvPr>
        </p:nvGraphicFramePr>
        <p:xfrm>
          <a:off x="5046742" y="15973160"/>
          <a:ext cx="15809496" cy="1422564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5809496">
                  <a:extLst>
                    <a:ext uri="{9D8B030D-6E8A-4147-A177-3AD203B41FA5}">
                      <a16:colId xmlns:a16="http://schemas.microsoft.com/office/drawing/2014/main" val="1177835138"/>
                    </a:ext>
                  </a:extLst>
                </a:gridCol>
              </a:tblGrid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racellular matrix organization </a:t>
                      </a:r>
                      <a:endParaRPr lang="en-US" sz="4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41552999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racellular structure organization </a:t>
                      </a:r>
                      <a:endParaRPr lang="en-US" sz="4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9186593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giogenesis</a:t>
                      </a:r>
                      <a:endParaRPr lang="en-US" sz="4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07538550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ulation of extrinsic apoptotic signaling pathway</a:t>
                      </a:r>
                      <a:endParaRPr lang="en-US" sz="4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2144318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ulation of cell adhesion mediated by integrin</a:t>
                      </a:r>
                      <a:endParaRPr lang="en-US" sz="4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72126182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ulation of hormone secretion</a:t>
                      </a:r>
                      <a:endParaRPr lang="en-US" sz="4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24487109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dothelial cell apoptotic process </a:t>
                      </a:r>
                      <a:endParaRPr lang="en-US" sz="4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25057860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-matrix adhesion</a:t>
                      </a:r>
                      <a:endParaRPr lang="en-US" sz="4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092084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-substrate adhesion </a:t>
                      </a:r>
                      <a:endParaRPr lang="en-US" sz="4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90204431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ulation of peptide secretion</a:t>
                      </a:r>
                      <a:endParaRPr lang="en-US" sz="4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66257182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ve regulation of secretion by cell</a:t>
                      </a:r>
                      <a:endParaRPr lang="en-US" sz="4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10121853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membrane receptor protein serine/threonine kinase signaling pathway</a:t>
                      </a:r>
                      <a:endParaRPr lang="en-US" sz="4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486621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adhesion mediated by integrin </a:t>
                      </a:r>
                      <a:endParaRPr lang="en-US" sz="4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46243759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pidermis development</a:t>
                      </a:r>
                      <a:endParaRPr lang="en-US" sz="4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62756789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rmone transport</a:t>
                      </a:r>
                      <a:endParaRPr lang="en-US" sz="4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19784660"/>
                  </a:ext>
                </a:extLst>
              </a:tr>
            </a:tbl>
          </a:graphicData>
        </a:graphic>
      </p:graphicFrame>
      <p:graphicFrame>
        <p:nvGraphicFramePr>
          <p:cNvPr id="54" name="表 53">
            <a:extLst>
              <a:ext uri="{FF2B5EF4-FFF2-40B4-BE49-F238E27FC236}">
                <a16:creationId xmlns:a16="http://schemas.microsoft.com/office/drawing/2014/main" id="{DFF06C20-0F0F-4A70-B164-4FC3CFFAA23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71363233"/>
              </p:ext>
            </p:extLst>
          </p:nvPr>
        </p:nvGraphicFramePr>
        <p:xfrm>
          <a:off x="4965888" y="30794507"/>
          <a:ext cx="15809496" cy="1387629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5809496">
                  <a:extLst>
                    <a:ext uri="{9D8B030D-6E8A-4147-A177-3AD203B41FA5}">
                      <a16:colId xmlns:a16="http://schemas.microsoft.com/office/drawing/2014/main" val="1177835138"/>
                    </a:ext>
                  </a:extLst>
                </a:gridCol>
              </a:tblGrid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esponse to interferon-gamma</a:t>
                      </a: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41552999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egulation of immune effector process</a:t>
                      </a: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79186593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umoral immune response</a:t>
                      </a: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07538550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cute inflammatory response</a:t>
                      </a: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72144318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Defense response to other organism</a:t>
                      </a: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72126182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omplement activation </a:t>
                      </a: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24487109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ositive regulation of leukocyte proliferation</a:t>
                      </a: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25057860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egulation of complement activation</a:t>
                      </a: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4092084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egulation of humoral immune response</a:t>
                      </a: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90204431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egulation of protein activation cascade </a:t>
                      </a: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66257182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ositive regulation of lymphocyte proliferation</a:t>
                      </a: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10121853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rotein activation cascade</a:t>
                      </a: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486621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egulation of acute inflammatory response </a:t>
                      </a: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46243759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egulation of multi-organism process </a:t>
                      </a: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62756789"/>
                  </a:ext>
                </a:extLst>
              </a:tr>
              <a:tr h="925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egulation of protein processing</a:t>
                      </a:r>
                    </a:p>
                  </a:txBody>
                  <a:tcPr marL="9525" marR="9525" marT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1978466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3338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正方形/長方形 60">
            <a:extLst>
              <a:ext uri="{FF2B5EF4-FFF2-40B4-BE49-F238E27FC236}">
                <a16:creationId xmlns:a16="http://schemas.microsoft.com/office/drawing/2014/main" id="{A5E1A4AF-19DE-4434-B743-ECB09830B31A}"/>
              </a:ext>
            </a:extLst>
          </p:cNvPr>
          <p:cNvSpPr/>
          <p:nvPr/>
        </p:nvSpPr>
        <p:spPr>
          <a:xfrm>
            <a:off x="0" y="0"/>
            <a:ext cx="12107802" cy="228280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endParaRPr lang="en-US" altLang="ja-JP" sz="7117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7117" b="1" dirty="0">
                <a:latin typeface="Arial" panose="020B0604020202020204" pitchFamily="34" charset="0"/>
                <a:cs typeface="Arial" panose="020B0604020202020204" pitchFamily="34" charset="0"/>
              </a:rPr>
              <a:t>   Supplementary</a:t>
            </a:r>
            <a:r>
              <a:rPr lang="ja-JP" altLang="en-US" sz="7117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7117" b="1" dirty="0">
                <a:latin typeface="Arial" panose="020B0604020202020204" pitchFamily="34" charset="0"/>
                <a:cs typeface="Arial" panose="020B0604020202020204" pitchFamily="34" charset="0"/>
              </a:rPr>
              <a:t>FigureS3</a:t>
            </a:r>
            <a:endParaRPr lang="ja-JP" altLang="en-US" sz="7117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6E5CDE5A-58BE-490D-9AE9-7390AC01EA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9056" y="5085107"/>
            <a:ext cx="33951008" cy="135445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294809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2D8007C2-62B1-4A5C-82CD-C3BCE5933F44}"/>
              </a:ext>
            </a:extLst>
          </p:cNvPr>
          <p:cNvSpPr/>
          <p:nvPr/>
        </p:nvSpPr>
        <p:spPr>
          <a:xfrm>
            <a:off x="6396149" y="22317050"/>
            <a:ext cx="24164062" cy="11880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712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4800" dirty="0">
                <a:latin typeface="Arial" panose="020B0604020202020204" pitchFamily="34" charset="0"/>
                <a:cs typeface="Arial" panose="020B0604020202020204" pitchFamily="34" charset="0"/>
              </a:rPr>
              <a:t>  Among</a:t>
            </a:r>
            <a:r>
              <a:rPr lang="ja-JP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4800" dirty="0">
                <a:latin typeface="Arial" panose="020B0604020202020204" pitchFamily="34" charset="0"/>
                <a:cs typeface="Arial" panose="020B0604020202020204" pitchFamily="34" charset="0"/>
              </a:rPr>
              <a:t>30 clones,</a:t>
            </a:r>
            <a:r>
              <a:rPr lang="ja-JP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4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ja-JP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4800" dirty="0">
                <a:latin typeface="Arial" panose="020B0604020202020204" pitchFamily="34" charset="0"/>
                <a:cs typeface="Arial" panose="020B0604020202020204" pitchFamily="34" charset="0"/>
              </a:rPr>
              <a:t>clone</a:t>
            </a:r>
            <a:r>
              <a:rPr lang="ja-JP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4800" dirty="0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ja-JP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4800" dirty="0">
                <a:latin typeface="Arial" panose="020B0604020202020204" pitchFamily="34" charset="0"/>
                <a:cs typeface="Arial" panose="020B0604020202020204" pitchFamily="34" charset="0"/>
              </a:rPr>
              <a:t>homo-knockout and 10 clones were hetero-knockout</a:t>
            </a:r>
            <a:endParaRPr lang="ja-JP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5454ECF2-87C8-4340-8072-67A1B84860C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96303" y="13348216"/>
            <a:ext cx="8741587" cy="7006284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FD9AAA29-7B15-4DF6-927F-38008E435E7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37890" y="13554283"/>
            <a:ext cx="8719895" cy="6594150"/>
          </a:xfrm>
          <a:prstGeom prst="rect">
            <a:avLst/>
          </a:prstGeom>
        </p:spPr>
      </p:pic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A5BD2A50-A323-42F4-BA71-B9A91B51EA23}"/>
              </a:ext>
            </a:extLst>
          </p:cNvPr>
          <p:cNvSpPr/>
          <p:nvPr/>
        </p:nvSpPr>
        <p:spPr>
          <a:xfrm>
            <a:off x="19605076" y="25775988"/>
            <a:ext cx="9509028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4800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  <a:r>
              <a:rPr lang="ja-JP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lang="en-US" altLang="ja-JP" sz="4800" dirty="0">
                <a:latin typeface="Arial" panose="020B0604020202020204" pitchFamily="34" charset="0"/>
                <a:cs typeface="Arial" panose="020B0604020202020204" pitchFamily="34" charset="0"/>
              </a:rPr>
              <a:t>Control (white)</a:t>
            </a:r>
            <a:r>
              <a:rPr lang="ja-JP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lang="en-US" altLang="ja-JP" sz="4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4800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  <a:r>
              <a:rPr lang="ja-JP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lang="en-US" altLang="ja-JP" sz="4800" dirty="0">
                <a:latin typeface="Arial" panose="020B0604020202020204" pitchFamily="34" charset="0"/>
                <a:cs typeface="Arial" panose="020B0604020202020204" pitchFamily="34" charset="0"/>
              </a:rPr>
              <a:t>hetero-knock-out (blue)</a:t>
            </a:r>
          </a:p>
          <a:p>
            <a:r>
              <a:rPr lang="en-US" altLang="ja-JP" sz="4800" dirty="0">
                <a:latin typeface="Arial" panose="020B0604020202020204" pitchFamily="34" charset="0"/>
                <a:cs typeface="Arial" panose="020B0604020202020204" pitchFamily="34" charset="0"/>
              </a:rPr>
              <a:t>#3</a:t>
            </a:r>
            <a:r>
              <a:rPr lang="ja-JP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lang="en-US" altLang="ja-JP" sz="4800" dirty="0">
                <a:latin typeface="Arial" panose="020B0604020202020204" pitchFamily="34" charset="0"/>
                <a:cs typeface="Arial" panose="020B0604020202020204" pitchFamily="34" charset="0"/>
              </a:rPr>
              <a:t>homo-knock-out (red)</a:t>
            </a:r>
          </a:p>
          <a:p>
            <a:r>
              <a:rPr lang="en-US" altLang="ja-JP" sz="4800" dirty="0">
                <a:latin typeface="Arial" panose="020B0604020202020204" pitchFamily="34" charset="0"/>
                <a:cs typeface="Arial" panose="020B0604020202020204" pitchFamily="34" charset="0"/>
              </a:rPr>
              <a:t>#1~#3 were</a:t>
            </a:r>
            <a:r>
              <a:rPr lang="ja-JP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4800" dirty="0">
                <a:latin typeface="Arial" panose="020B0604020202020204" pitchFamily="34" charset="0"/>
                <a:cs typeface="Arial" panose="020B0604020202020204" pitchFamily="34" charset="0"/>
              </a:rPr>
              <a:t>selected</a:t>
            </a:r>
            <a:endParaRPr lang="ja-JP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D71E73C7-64F3-4FFE-9DA9-EB9618905C22}"/>
              </a:ext>
            </a:extLst>
          </p:cNvPr>
          <p:cNvGrpSpPr>
            <a:grpSpLocks noChangeAspect="1"/>
          </p:cNvGrpSpPr>
          <p:nvPr/>
        </p:nvGrpSpPr>
        <p:grpSpPr>
          <a:xfrm>
            <a:off x="9144511" y="23530920"/>
            <a:ext cx="9470052" cy="7590141"/>
            <a:chOff x="2023657" y="6824159"/>
            <a:chExt cx="1842516" cy="1476756"/>
          </a:xfrm>
        </p:grpSpPr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6DED37A8-A930-464A-A44F-87290B86365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23657" y="6824159"/>
              <a:ext cx="1842516" cy="1476756"/>
            </a:xfrm>
            <a:prstGeom prst="rect">
              <a:avLst/>
            </a:prstGeom>
          </p:spPr>
        </p:pic>
        <p:sp>
          <p:nvSpPr>
            <p:cNvPr id="10" name="矢印: 右 9">
              <a:extLst>
                <a:ext uri="{FF2B5EF4-FFF2-40B4-BE49-F238E27FC236}">
                  <a16:creationId xmlns:a16="http://schemas.microsoft.com/office/drawing/2014/main" id="{13BF766F-DF96-4234-AF75-C4E893214DD5}"/>
                </a:ext>
              </a:extLst>
            </p:cNvPr>
            <p:cNvSpPr/>
            <p:nvPr/>
          </p:nvSpPr>
          <p:spPr>
            <a:xfrm rot="16200000">
              <a:off x="2499450" y="7544310"/>
              <a:ext cx="134718" cy="45719"/>
            </a:xfrm>
            <a:prstGeom prst="rightArrow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7117"/>
            </a:p>
          </p:txBody>
        </p:sp>
        <p:sp>
          <p:nvSpPr>
            <p:cNvPr id="11" name="矢印: 右 10">
              <a:extLst>
                <a:ext uri="{FF2B5EF4-FFF2-40B4-BE49-F238E27FC236}">
                  <a16:creationId xmlns:a16="http://schemas.microsoft.com/office/drawing/2014/main" id="{3316D285-90CB-47BF-AEC3-2D4222311CC6}"/>
                </a:ext>
              </a:extLst>
            </p:cNvPr>
            <p:cNvSpPr/>
            <p:nvPr/>
          </p:nvSpPr>
          <p:spPr>
            <a:xfrm rot="16200000">
              <a:off x="2220198" y="7550182"/>
              <a:ext cx="134718" cy="45719"/>
            </a:xfrm>
            <a:prstGeom prst="rightArrow">
              <a:avLst/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7117"/>
            </a:p>
          </p:txBody>
        </p:sp>
        <p:sp>
          <p:nvSpPr>
            <p:cNvPr id="12" name="矢印: 右 11">
              <a:extLst>
                <a:ext uri="{FF2B5EF4-FFF2-40B4-BE49-F238E27FC236}">
                  <a16:creationId xmlns:a16="http://schemas.microsoft.com/office/drawing/2014/main" id="{2E3D6092-5B1B-42D4-B629-BA42ABC631D0}"/>
                </a:ext>
              </a:extLst>
            </p:cNvPr>
            <p:cNvSpPr/>
            <p:nvPr/>
          </p:nvSpPr>
          <p:spPr>
            <a:xfrm rot="5400000">
              <a:off x="2137536" y="7182799"/>
              <a:ext cx="134718" cy="45719"/>
            </a:xfrm>
            <a:prstGeom prst="rightArrow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7117"/>
            </a:p>
          </p:txBody>
        </p:sp>
      </p:grp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B7B0F5E8-A5DD-44E4-92D2-B3A4219B3FFA}"/>
              </a:ext>
            </a:extLst>
          </p:cNvPr>
          <p:cNvSpPr txBox="1"/>
          <p:nvPr/>
        </p:nvSpPr>
        <p:spPr>
          <a:xfrm>
            <a:off x="9144511" y="12092126"/>
            <a:ext cx="13106473" cy="11880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12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kumimoji="1" lang="en-US" altLang="ja-JP" sz="4800" dirty="0">
                <a:latin typeface="Arial" panose="020B0604020202020204" pitchFamily="34" charset="0"/>
                <a:cs typeface="Arial" panose="020B0604020202020204" pitchFamily="34" charset="0"/>
              </a:rPr>
              <a:t>  Knock-out mutant screening by colony PCR</a:t>
            </a:r>
            <a:endParaRPr kumimoji="1" lang="ja-JP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EBE62E44-D2B8-4D0B-B485-8715578F9AF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75252541"/>
              </p:ext>
            </p:extLst>
          </p:nvPr>
        </p:nvGraphicFramePr>
        <p:xfrm>
          <a:off x="6566385" y="6230564"/>
          <a:ext cx="21403395" cy="36491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4857881">
                  <a:extLst>
                    <a:ext uri="{9D8B030D-6E8A-4147-A177-3AD203B41FA5}">
                      <a16:colId xmlns:a16="http://schemas.microsoft.com/office/drawing/2014/main" val="939501721"/>
                    </a:ext>
                  </a:extLst>
                </a:gridCol>
                <a:gridCol w="16545514">
                  <a:extLst>
                    <a:ext uri="{9D8B030D-6E8A-4147-A177-3AD203B41FA5}">
                      <a16:colId xmlns:a16="http://schemas.microsoft.com/office/drawing/2014/main" val="3228268361"/>
                    </a:ext>
                  </a:extLst>
                </a:gridCol>
              </a:tblGrid>
              <a:tr h="1641680">
                <a:tc>
                  <a:txBody>
                    <a:bodyPr/>
                    <a:lstStyle/>
                    <a:p>
                      <a:r>
                        <a:rPr kumimoji="1" lang="en-US" altLang="ja-JP" sz="4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uide RNA1</a:t>
                      </a:r>
                      <a:endParaRPr kumimoji="1" lang="ja-JP" altLang="en-US" sz="4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1522" marR="361522" marT="180760" marB="180760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4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ense, ACACCGACCTGAACCTCGTGACCACCG antisense, AAAACGGTGGTCACGAGGTTCAGGTCG</a:t>
                      </a:r>
                      <a:endParaRPr kumimoji="1" lang="ja-JP" altLang="en-US" sz="4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1522" marR="361522" marT="180760" marB="180760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3129685"/>
                  </a:ext>
                </a:extLst>
              </a:tr>
              <a:tr h="1641680">
                <a:tc>
                  <a:txBody>
                    <a:bodyPr/>
                    <a:lstStyle/>
                    <a:p>
                      <a:r>
                        <a:rPr kumimoji="1" lang="en-US" altLang="ja-JP" sz="4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uide RNA2</a:t>
                      </a:r>
                      <a:endParaRPr kumimoji="1" lang="ja-JP" altLang="en-US" sz="4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1522" marR="361522" marT="180760" marB="180760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81601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4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ense, ACACCGTTGGCATTGTACCGACATTG  </a:t>
                      </a:r>
                    </a:p>
                    <a:p>
                      <a:pPr marL="0" marR="0" lvl="0" indent="0" algn="l" defTabSz="81601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4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ntisense, AAAAC AATGTCGGTACAATGCCAACG</a:t>
                      </a:r>
                      <a:endParaRPr kumimoji="1" lang="ja-JP" altLang="ja-JP" sz="48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522" marR="361522" marT="180760" marB="180760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3148945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5BFCFF9-13E1-48B9-84CB-59A305998B79}"/>
              </a:ext>
            </a:extLst>
          </p:cNvPr>
          <p:cNvSpPr txBox="1"/>
          <p:nvPr/>
        </p:nvSpPr>
        <p:spPr>
          <a:xfrm>
            <a:off x="8359934" y="3937862"/>
            <a:ext cx="14752436" cy="11880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12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n-US" altLang="ja-JP" sz="4800" dirty="0">
                <a:latin typeface="Arial" panose="020B0604020202020204" pitchFamily="34" charset="0"/>
                <a:cs typeface="Arial" panose="020B0604020202020204" pitchFamily="34" charset="0"/>
              </a:rPr>
              <a:t>   Design</a:t>
            </a:r>
            <a:r>
              <a:rPr kumimoji="1" lang="ja-JP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4800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kumimoji="1" lang="ja-JP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4800" dirty="0">
                <a:latin typeface="Arial" panose="020B0604020202020204" pitchFamily="34" charset="0"/>
                <a:cs typeface="Arial" panose="020B0604020202020204" pitchFamily="34" charset="0"/>
              </a:rPr>
              <a:t>guide</a:t>
            </a:r>
            <a:r>
              <a:rPr kumimoji="1" lang="ja-JP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4800" dirty="0">
                <a:latin typeface="Arial" panose="020B0604020202020204" pitchFamily="34" charset="0"/>
                <a:cs typeface="Arial" panose="020B0604020202020204" pitchFamily="34" charset="0"/>
              </a:rPr>
              <a:t>RNA</a:t>
            </a:r>
            <a:r>
              <a:rPr kumimoji="1" lang="ja-JP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48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kumimoji="1" lang="ja-JP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4800" dirty="0">
                <a:latin typeface="Arial" panose="020B0604020202020204" pitchFamily="34" charset="0"/>
                <a:cs typeface="Arial" panose="020B0604020202020204" pitchFamily="34" charset="0"/>
              </a:rPr>
              <a:t>annealing</a:t>
            </a:r>
            <a:r>
              <a:rPr kumimoji="1" lang="ja-JP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4800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kumimoji="1" lang="ja-JP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4800" dirty="0">
                <a:latin typeface="Arial" panose="020B0604020202020204" pitchFamily="34" charset="0"/>
                <a:cs typeface="Arial" panose="020B0604020202020204" pitchFamily="34" charset="0"/>
              </a:rPr>
              <a:t>oligo</a:t>
            </a:r>
            <a:r>
              <a:rPr kumimoji="1" lang="ja-JP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4800" dirty="0">
                <a:latin typeface="Arial" panose="020B0604020202020204" pitchFamily="34" charset="0"/>
                <a:cs typeface="Arial" panose="020B0604020202020204" pitchFamily="34" charset="0"/>
              </a:rPr>
              <a:t>RNA</a:t>
            </a:r>
            <a:endParaRPr kumimoji="1" lang="ja-JP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図 20">
            <a:extLst>
              <a:ext uri="{FF2B5EF4-FFF2-40B4-BE49-F238E27FC236}">
                <a16:creationId xmlns:a16="http://schemas.microsoft.com/office/drawing/2014/main" id="{BE333730-5FB5-4AF2-842A-510962F97581}"/>
              </a:ext>
            </a:extLst>
          </p:cNvPr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96149" y="34593733"/>
            <a:ext cx="16478266" cy="12143303"/>
          </a:xfrm>
          <a:prstGeom prst="rect">
            <a:avLst/>
          </a:prstGeom>
          <a:noFill/>
          <a:ln>
            <a:noFill/>
          </a:ln>
        </p:spPr>
      </p:pic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6FD8957C-D2BE-4662-AC9A-4C1B7BF1C629}"/>
              </a:ext>
            </a:extLst>
          </p:cNvPr>
          <p:cNvSpPr/>
          <p:nvPr/>
        </p:nvSpPr>
        <p:spPr>
          <a:xfrm>
            <a:off x="22886799" y="38442763"/>
            <a:ext cx="10165961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48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DNA sequence confirmed 1st coding region of FOLR1</a:t>
            </a:r>
            <a:r>
              <a:rPr lang="ja-JP" altLang="en-US" sz="48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48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is</a:t>
            </a:r>
            <a:r>
              <a:rPr lang="ja-JP" altLang="en-US" sz="48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48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knock-out </a:t>
            </a:r>
            <a:endParaRPr lang="ja-JP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23DBFE4A-D48E-4010-B022-2C7A2736B64F}"/>
              </a:ext>
            </a:extLst>
          </p:cNvPr>
          <p:cNvSpPr/>
          <p:nvPr/>
        </p:nvSpPr>
        <p:spPr>
          <a:xfrm>
            <a:off x="0" y="32601"/>
            <a:ext cx="12107802" cy="228280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endParaRPr lang="en-US" altLang="ja-JP" sz="7117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7117" b="1" dirty="0">
                <a:latin typeface="Arial" panose="020B0604020202020204" pitchFamily="34" charset="0"/>
                <a:cs typeface="Arial" panose="020B0604020202020204" pitchFamily="34" charset="0"/>
              </a:rPr>
              <a:t>   Supplementary FigureS4</a:t>
            </a:r>
            <a:endParaRPr lang="ja-JP" altLang="en-US" sz="7117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図 15">
            <a:extLst>
              <a:ext uri="{FF2B5EF4-FFF2-40B4-BE49-F238E27FC236}">
                <a16:creationId xmlns:a16="http://schemas.microsoft.com/office/drawing/2014/main" id="{C20AE2FA-0314-4359-BD9D-2B069CB0988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93570" y="13849267"/>
            <a:ext cx="8745451" cy="5890666"/>
          </a:xfrm>
          <a:prstGeom prst="rect">
            <a:avLst/>
          </a:prstGeom>
        </p:spPr>
      </p:pic>
      <p:sp>
        <p:nvSpPr>
          <p:cNvPr id="23" name="楕円 22">
            <a:extLst>
              <a:ext uri="{FF2B5EF4-FFF2-40B4-BE49-F238E27FC236}">
                <a16:creationId xmlns:a16="http://schemas.microsoft.com/office/drawing/2014/main" id="{AA376CC9-EC4D-45F8-8F55-BC12E75916B2}"/>
              </a:ext>
            </a:extLst>
          </p:cNvPr>
          <p:cNvSpPr/>
          <p:nvPr/>
        </p:nvSpPr>
        <p:spPr>
          <a:xfrm>
            <a:off x="4582107" y="14193854"/>
            <a:ext cx="4733525" cy="5199118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73"/>
          </a:p>
        </p:txBody>
      </p: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6B819E1F-DE62-4E86-A0B9-36F82BE3E900}"/>
              </a:ext>
            </a:extLst>
          </p:cNvPr>
          <p:cNvCxnSpPr>
            <a:cxnSpLocks/>
            <a:stCxn id="23" idx="6"/>
          </p:cNvCxnSpPr>
          <p:nvPr/>
        </p:nvCxnSpPr>
        <p:spPr>
          <a:xfrm>
            <a:off x="9315632" y="16793413"/>
            <a:ext cx="4236098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38BB5F8-2BFE-43F6-8EAB-BC8E7214AF07}"/>
              </a:ext>
            </a:extLst>
          </p:cNvPr>
          <p:cNvSpPr txBox="1"/>
          <p:nvPr/>
        </p:nvSpPr>
        <p:spPr>
          <a:xfrm>
            <a:off x="5749330" y="33405715"/>
            <a:ext cx="843501" cy="11880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12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712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28178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61</TotalTime>
  <Words>237</Words>
  <Application>Microsoft Office PowerPoint</Application>
  <PresentationFormat>ユーザー設定</PresentationFormat>
  <Paragraphs>69</Paragraphs>
  <Slides>4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yunaisec</dc:creator>
  <cp:lastModifiedBy>先端がん治療研究所</cp:lastModifiedBy>
  <cp:revision>153</cp:revision>
  <cp:lastPrinted>2021-03-18T10:18:15Z</cp:lastPrinted>
  <dcterms:created xsi:type="dcterms:W3CDTF">2020-03-19T06:53:50Z</dcterms:created>
  <dcterms:modified xsi:type="dcterms:W3CDTF">2021-05-03T14:27:44Z</dcterms:modified>
</cp:coreProperties>
</file>